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3.xml" ContentType="application/vnd.openxmlformats-officedocument.drawingml.chartshapes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7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83" r:id="rId3"/>
    <p:sldId id="260" r:id="rId4"/>
    <p:sldId id="267" r:id="rId5"/>
    <p:sldId id="281" r:id="rId6"/>
    <p:sldId id="256" r:id="rId7"/>
    <p:sldId id="282" r:id="rId8"/>
    <p:sldId id="259" r:id="rId9"/>
    <p:sldId id="284" r:id="rId10"/>
    <p:sldId id="28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84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Users\tka2001\Dropbox\NFATC3-fatima\skov3%20seahorese\skov3-si-anknfcirclin.xlsm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Users\tka2001\Dropbox\NFATC3-fatima\over%20expression-nfat\over%20expression%20nfat%20seahorse-mda-sk\MitoStress_NFATC3_overexpression_SKOV3.xlsm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ka2001\Dropbox\NFATC3-fatima\over%20expression-nfat\over%20expression%20nfat%20seahorse-mda-sk\MitoStress_NFATC3_overexpression_SKOV3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AL-DASIM\skov3%20seahorese\energy%20phenotye_NFATC3_1overexpression_SKOV3.xlsm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\\Users\tka2001\Dropbox\NFATC3-fatima\skov3%20seahorese\energy%20phenotye_NFATC3_overexpression_SKOV3.xlsm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hasni\Dropbox\NFATC3-fatima\results-nfat\phenotype%20knockdown-nfatapri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hasni\Dropbox\NFATC3-fatima\results-nfat\phenotype%20knockdown-nfatapril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lang="en-US"/>
            </a:pPr>
            <a:r>
              <a:rPr lang="en-US"/>
              <a:t>Mitochondrial Respiration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9979454358726787"/>
          <c:y val="0.11532852055399444"/>
          <c:w val="0.59259368024207548"/>
          <c:h val="0.69126276970443945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mmary Printout'!$AB$103</c:f>
              <c:strCache>
                <c:ptCount val="1"/>
                <c:pt idx="0">
                  <c:v>Group 1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chemeClr val="accent6">
                  <a:lumMod val="75000"/>
                </a:schemeClr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N$104:$AN$115</c:f>
                <c:numCache>
                  <c:formatCode>General</c:formatCode>
                  <c:ptCount val="12"/>
                  <c:pt idx="0">
                    <c:v>2.7834307499399871</c:v>
                  </c:pt>
                  <c:pt idx="1">
                    <c:v>2.6121792635981831</c:v>
                  </c:pt>
                  <c:pt idx="2">
                    <c:v>3.3707781170632378</c:v>
                  </c:pt>
                  <c:pt idx="3">
                    <c:v>2.9323676882475409</c:v>
                  </c:pt>
                  <c:pt idx="4">
                    <c:v>2.3567935024994435</c:v>
                  </c:pt>
                  <c:pt idx="5">
                    <c:v>2.4310790993394997</c:v>
                  </c:pt>
                  <c:pt idx="6">
                    <c:v>6.1326442723606931</c:v>
                  </c:pt>
                  <c:pt idx="7">
                    <c:v>8.5611122130891246</c:v>
                  </c:pt>
                  <c:pt idx="8">
                    <c:v>9.588849968864297</c:v>
                  </c:pt>
                  <c:pt idx="9">
                    <c:v>5.1251134207869571</c:v>
                  </c:pt>
                  <c:pt idx="10">
                    <c:v>5.0175124485346183</c:v>
                  </c:pt>
                  <c:pt idx="11">
                    <c:v>5.0729530877604896</c:v>
                  </c:pt>
                </c:numCache>
              </c:numRef>
            </c:plus>
            <c:minus>
              <c:numRef>
                <c:f>'Summary Printout'!$AN$104:$AN$115</c:f>
                <c:numCache>
                  <c:formatCode>General</c:formatCode>
                  <c:ptCount val="12"/>
                  <c:pt idx="0">
                    <c:v>2.7834307499399871</c:v>
                  </c:pt>
                  <c:pt idx="1">
                    <c:v>2.6121792635981831</c:v>
                  </c:pt>
                  <c:pt idx="2">
                    <c:v>3.3707781170632378</c:v>
                  </c:pt>
                  <c:pt idx="3">
                    <c:v>2.9323676882475409</c:v>
                  </c:pt>
                  <c:pt idx="4">
                    <c:v>2.3567935024994435</c:v>
                  </c:pt>
                  <c:pt idx="5">
                    <c:v>2.4310790993394997</c:v>
                  </c:pt>
                  <c:pt idx="6">
                    <c:v>6.1326442723606931</c:v>
                  </c:pt>
                  <c:pt idx="7">
                    <c:v>8.5611122130891246</c:v>
                  </c:pt>
                  <c:pt idx="8">
                    <c:v>9.588849968864297</c:v>
                  </c:pt>
                  <c:pt idx="9">
                    <c:v>5.1251134207869571</c:v>
                  </c:pt>
                  <c:pt idx="10">
                    <c:v>5.0175124485346183</c:v>
                  </c:pt>
                  <c:pt idx="11">
                    <c:v>5.0729530877604896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B$104:$AB$115</c:f>
              <c:numCache>
                <c:formatCode>0.0</c:formatCode>
                <c:ptCount val="12"/>
                <c:pt idx="0">
                  <c:v>141.98382732126271</c:v>
                </c:pt>
                <c:pt idx="1">
                  <c:v>130.79487454523183</c:v>
                </c:pt>
                <c:pt idx="2">
                  <c:v>128.78014691279029</c:v>
                </c:pt>
                <c:pt idx="3">
                  <c:v>85.692723964907586</c:v>
                </c:pt>
                <c:pt idx="4">
                  <c:v>76.405420894146189</c:v>
                </c:pt>
                <c:pt idx="5">
                  <c:v>74.664641323590004</c:v>
                </c:pt>
                <c:pt idx="6">
                  <c:v>97.973165834627167</c:v>
                </c:pt>
                <c:pt idx="7">
                  <c:v>104.11846594482039</c:v>
                </c:pt>
                <c:pt idx="8">
                  <c:v>108.82753592964013</c:v>
                </c:pt>
                <c:pt idx="9">
                  <c:v>51.563093349626925</c:v>
                </c:pt>
                <c:pt idx="10">
                  <c:v>49.982169969423083</c:v>
                </c:pt>
                <c:pt idx="11">
                  <c:v>48.500319234794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8DF-4B0C-83F0-174FDF443E44}"/>
            </c:ext>
          </c:extLst>
        </c:ser>
        <c:ser>
          <c:idx val="1"/>
          <c:order val="1"/>
          <c:tx>
            <c:strRef>
              <c:f>'Summary Printout'!$AC$103</c:f>
              <c:strCache>
                <c:ptCount val="1"/>
                <c:pt idx="0">
                  <c:v>Group 2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O$104:$AO$115</c:f>
                <c:numCache>
                  <c:formatCode>General</c:formatCode>
                  <c:ptCount val="12"/>
                  <c:pt idx="0">
                    <c:v>0.95718516913423501</c:v>
                  </c:pt>
                  <c:pt idx="1">
                    <c:v>1.0648780681245913</c:v>
                  </c:pt>
                  <c:pt idx="2">
                    <c:v>1.2576803032915183</c:v>
                  </c:pt>
                  <c:pt idx="3">
                    <c:v>0.91740296930349763</c:v>
                  </c:pt>
                  <c:pt idx="4">
                    <c:v>1.2023712740215642</c:v>
                  </c:pt>
                  <c:pt idx="5">
                    <c:v>1.2088010604252453</c:v>
                  </c:pt>
                  <c:pt idx="6">
                    <c:v>2.6197934416855051</c:v>
                  </c:pt>
                  <c:pt idx="7">
                    <c:v>3.1689675985285053</c:v>
                  </c:pt>
                  <c:pt idx="8">
                    <c:v>3.6213771952757687</c:v>
                  </c:pt>
                  <c:pt idx="9">
                    <c:v>4.7555842116650258</c:v>
                  </c:pt>
                  <c:pt idx="10">
                    <c:v>4.8498663707822951</c:v>
                  </c:pt>
                  <c:pt idx="11">
                    <c:v>5.0249164901819965</c:v>
                  </c:pt>
                </c:numCache>
              </c:numRef>
            </c:plus>
            <c:minus>
              <c:numRef>
                <c:f>'Summary Printout'!$AO$104:$AO$115</c:f>
                <c:numCache>
                  <c:formatCode>General</c:formatCode>
                  <c:ptCount val="12"/>
                  <c:pt idx="0">
                    <c:v>0.95718516913423501</c:v>
                  </c:pt>
                  <c:pt idx="1">
                    <c:v>1.0648780681245913</c:v>
                  </c:pt>
                  <c:pt idx="2">
                    <c:v>1.2576803032915183</c:v>
                  </c:pt>
                  <c:pt idx="3">
                    <c:v>0.91740296930349763</c:v>
                  </c:pt>
                  <c:pt idx="4">
                    <c:v>1.2023712740215642</c:v>
                  </c:pt>
                  <c:pt idx="5">
                    <c:v>1.2088010604252453</c:v>
                  </c:pt>
                  <c:pt idx="6">
                    <c:v>2.6197934416855051</c:v>
                  </c:pt>
                  <c:pt idx="7">
                    <c:v>3.1689675985285053</c:v>
                  </c:pt>
                  <c:pt idx="8">
                    <c:v>3.6213771952757687</c:v>
                  </c:pt>
                  <c:pt idx="9">
                    <c:v>4.7555842116650258</c:v>
                  </c:pt>
                  <c:pt idx="10">
                    <c:v>4.8498663707822951</c:v>
                  </c:pt>
                  <c:pt idx="11">
                    <c:v>5.0249164901819965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C$104:$AC$115</c:f>
              <c:numCache>
                <c:formatCode>0.0</c:formatCode>
                <c:ptCount val="12"/>
                <c:pt idx="0">
                  <c:v>128.36868180546418</c:v>
                </c:pt>
                <c:pt idx="1">
                  <c:v>119.12372180835364</c:v>
                </c:pt>
                <c:pt idx="2">
                  <c:v>115.5609944880007</c:v>
                </c:pt>
                <c:pt idx="3">
                  <c:v>78.743543952564551</c:v>
                </c:pt>
                <c:pt idx="4">
                  <c:v>71.502429074615122</c:v>
                </c:pt>
                <c:pt idx="5">
                  <c:v>69.862032546563213</c:v>
                </c:pt>
                <c:pt idx="6">
                  <c:v>79.271822332314542</c:v>
                </c:pt>
                <c:pt idx="7">
                  <c:v>82.232576217244386</c:v>
                </c:pt>
                <c:pt idx="8">
                  <c:v>85.41507051113058</c:v>
                </c:pt>
                <c:pt idx="9">
                  <c:v>52.592864660211539</c:v>
                </c:pt>
                <c:pt idx="10">
                  <c:v>51.098712098894929</c:v>
                </c:pt>
                <c:pt idx="11">
                  <c:v>49.9156883480763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8DF-4B0C-83F0-174FDF443E44}"/>
            </c:ext>
          </c:extLst>
        </c:ser>
        <c:ser>
          <c:idx val="2"/>
          <c:order val="2"/>
          <c:tx>
            <c:strRef>
              <c:f>'Summary Printout'!$AD$103</c:f>
              <c:strCache>
                <c:ptCount val="1"/>
                <c:pt idx="0">
                  <c:v>Group 3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rgbClr val="C00000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P$104:$AP$115</c:f>
                <c:numCache>
                  <c:formatCode>General</c:formatCode>
                  <c:ptCount val="12"/>
                  <c:pt idx="0">
                    <c:v>1.7223365663691417</c:v>
                  </c:pt>
                  <c:pt idx="1">
                    <c:v>1.7803101949628568</c:v>
                  </c:pt>
                  <c:pt idx="2">
                    <c:v>1.7229465466623668</c:v>
                  </c:pt>
                  <c:pt idx="3">
                    <c:v>0.96500539277525199</c:v>
                  </c:pt>
                  <c:pt idx="4">
                    <c:v>1.2098932133173161</c:v>
                  </c:pt>
                  <c:pt idx="5">
                    <c:v>1.114107703448038</c:v>
                  </c:pt>
                  <c:pt idx="6">
                    <c:v>3.250399199078835</c:v>
                  </c:pt>
                  <c:pt idx="7">
                    <c:v>4.6154542592533581</c:v>
                  </c:pt>
                  <c:pt idx="8">
                    <c:v>4.7279514295465992</c:v>
                  </c:pt>
                  <c:pt idx="9">
                    <c:v>3.8423399739977748</c:v>
                  </c:pt>
                  <c:pt idx="10">
                    <c:v>3.8767243031474381</c:v>
                  </c:pt>
                  <c:pt idx="11">
                    <c:v>3.8082142496745739</c:v>
                  </c:pt>
                </c:numCache>
              </c:numRef>
            </c:plus>
            <c:minus>
              <c:numRef>
                <c:f>'Summary Printout'!$AP$104:$AP$115</c:f>
                <c:numCache>
                  <c:formatCode>General</c:formatCode>
                  <c:ptCount val="12"/>
                  <c:pt idx="0">
                    <c:v>1.7223365663691417</c:v>
                  </c:pt>
                  <c:pt idx="1">
                    <c:v>1.7803101949628568</c:v>
                  </c:pt>
                  <c:pt idx="2">
                    <c:v>1.7229465466623668</c:v>
                  </c:pt>
                  <c:pt idx="3">
                    <c:v>0.96500539277525199</c:v>
                  </c:pt>
                  <c:pt idx="4">
                    <c:v>1.2098932133173161</c:v>
                  </c:pt>
                  <c:pt idx="5">
                    <c:v>1.114107703448038</c:v>
                  </c:pt>
                  <c:pt idx="6">
                    <c:v>3.250399199078835</c:v>
                  </c:pt>
                  <c:pt idx="7">
                    <c:v>4.6154542592533581</c:v>
                  </c:pt>
                  <c:pt idx="8">
                    <c:v>4.7279514295465992</c:v>
                  </c:pt>
                  <c:pt idx="9">
                    <c:v>3.8423399739977748</c:v>
                  </c:pt>
                  <c:pt idx="10">
                    <c:v>3.8767243031474381</c:v>
                  </c:pt>
                  <c:pt idx="11">
                    <c:v>3.8082142496745739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D$104:$AD$115</c:f>
              <c:numCache>
                <c:formatCode>0.0</c:formatCode>
                <c:ptCount val="12"/>
                <c:pt idx="0">
                  <c:v>127.7593653759124</c:v>
                </c:pt>
                <c:pt idx="1">
                  <c:v>118.53533367501988</c:v>
                </c:pt>
                <c:pt idx="2">
                  <c:v>115.18037994467871</c:v>
                </c:pt>
                <c:pt idx="3">
                  <c:v>79.487219654097302</c:v>
                </c:pt>
                <c:pt idx="4">
                  <c:v>71.608146033031218</c:v>
                </c:pt>
                <c:pt idx="5">
                  <c:v>69.80472513656585</c:v>
                </c:pt>
                <c:pt idx="6">
                  <c:v>75.828507130203121</c:v>
                </c:pt>
                <c:pt idx="7">
                  <c:v>81.195519992752367</c:v>
                </c:pt>
                <c:pt idx="8">
                  <c:v>83.433971386949409</c:v>
                </c:pt>
                <c:pt idx="9">
                  <c:v>48.680378040042903</c:v>
                </c:pt>
                <c:pt idx="10">
                  <c:v>47.403526706558658</c:v>
                </c:pt>
                <c:pt idx="11">
                  <c:v>46.6939601888445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8DF-4B0C-83F0-174FDF443E44}"/>
            </c:ext>
          </c:extLst>
        </c:ser>
        <c:ser>
          <c:idx val="3"/>
          <c:order val="3"/>
          <c:tx>
            <c:strRef>
              <c:f>'Summary Printout'!$AE$103</c:f>
              <c:strCache>
                <c:ptCount val="1"/>
                <c:pt idx="0">
                  <c:v>Unselec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Q$104:$AQ$115</c:f>
              </c:numRef>
            </c:plus>
            <c:minus>
              <c:numRef>
                <c:f>'Summary Printout'!$AQ$104:$AQ$115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E$104:$AE$115</c:f>
            </c:numRef>
          </c:yVal>
          <c:smooth val="0"/>
          <c:extLst>
            <c:ext xmlns:c16="http://schemas.microsoft.com/office/drawing/2014/chart" uri="{C3380CC4-5D6E-409C-BE32-E72D297353CC}">
              <c16:uniqueId val="{00000003-08DF-4B0C-83F0-174FDF443E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815872"/>
        <c:axId val="192818176"/>
      </c:scatterChart>
      <c:valAx>
        <c:axId val="192815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92818176"/>
        <c:crosses val="autoZero"/>
        <c:crossBetween val="midCat"/>
      </c:valAx>
      <c:valAx>
        <c:axId val="192818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OCR (pmol/min)</a:t>
                </a:r>
              </a:p>
            </c:rich>
          </c:tx>
          <c:layout/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9281587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itochondrial Respiration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mmary Printout'!$AB$103</c:f>
              <c:strCache>
                <c:ptCount val="1"/>
                <c:pt idx="0">
                  <c:v>Group 1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chemeClr val="accent1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R$104:$AR$115</c:f>
                <c:numCache>
                  <c:formatCode>General</c:formatCode>
                  <c:ptCount val="12"/>
                  <c:pt idx="0">
                    <c:v>3.0472599982995621</c:v>
                  </c:pt>
                  <c:pt idx="1">
                    <c:v>2.6354788454018463</c:v>
                  </c:pt>
                  <c:pt idx="2">
                    <c:v>2.5581139552800005</c:v>
                  </c:pt>
                  <c:pt idx="3">
                    <c:v>2.1242162218193248</c:v>
                  </c:pt>
                  <c:pt idx="4">
                    <c:v>2.192154243668885</c:v>
                  </c:pt>
                  <c:pt idx="5">
                    <c:v>2.1052422857267459</c:v>
                  </c:pt>
                  <c:pt idx="6">
                    <c:v>2.7149295686261383</c:v>
                  </c:pt>
                  <c:pt idx="7">
                    <c:v>2.8480932326864568</c:v>
                  </c:pt>
                  <c:pt idx="8">
                    <c:v>2.8700611279778463</c:v>
                  </c:pt>
                  <c:pt idx="9">
                    <c:v>1.3201407412207029</c:v>
                  </c:pt>
                  <c:pt idx="10">
                    <c:v>1.2772496757744605</c:v>
                  </c:pt>
                  <c:pt idx="11">
                    <c:v>1.235822363141714</c:v>
                  </c:pt>
                </c:numCache>
              </c:numRef>
            </c:plus>
            <c:minus>
              <c:numRef>
                <c:f>'Summary Printout'!$AR$104:$AR$115</c:f>
                <c:numCache>
                  <c:formatCode>General</c:formatCode>
                  <c:ptCount val="12"/>
                  <c:pt idx="0">
                    <c:v>3.0472599982995621</c:v>
                  </c:pt>
                  <c:pt idx="1">
                    <c:v>2.6354788454018463</c:v>
                  </c:pt>
                  <c:pt idx="2">
                    <c:v>2.5581139552800005</c:v>
                  </c:pt>
                  <c:pt idx="3">
                    <c:v>2.1242162218193248</c:v>
                  </c:pt>
                  <c:pt idx="4">
                    <c:v>2.192154243668885</c:v>
                  </c:pt>
                  <c:pt idx="5">
                    <c:v>2.1052422857267459</c:v>
                  </c:pt>
                  <c:pt idx="6">
                    <c:v>2.7149295686261383</c:v>
                  </c:pt>
                  <c:pt idx="7">
                    <c:v>2.8480932326864568</c:v>
                  </c:pt>
                  <c:pt idx="8">
                    <c:v>2.8700611279778463</c:v>
                  </c:pt>
                  <c:pt idx="9">
                    <c:v>1.3201407412207029</c:v>
                  </c:pt>
                  <c:pt idx="10">
                    <c:v>1.2772496757744605</c:v>
                  </c:pt>
                  <c:pt idx="11">
                    <c:v>1.23582236314171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B$104:$AB$115</c:f>
              <c:numCache>
                <c:formatCode>0.0</c:formatCode>
                <c:ptCount val="12"/>
                <c:pt idx="0">
                  <c:v>76.294401887855415</c:v>
                </c:pt>
                <c:pt idx="1">
                  <c:v>70.16343455211063</c:v>
                </c:pt>
                <c:pt idx="2">
                  <c:v>68.688810545327314</c:v>
                </c:pt>
                <c:pt idx="3">
                  <c:v>56.748214371152962</c:v>
                </c:pt>
                <c:pt idx="4">
                  <c:v>56.395216501665644</c:v>
                </c:pt>
                <c:pt idx="5">
                  <c:v>55.146657583777333</c:v>
                </c:pt>
                <c:pt idx="6">
                  <c:v>63.908037815606818</c:v>
                </c:pt>
                <c:pt idx="7">
                  <c:v>64.306091069379647</c:v>
                </c:pt>
                <c:pt idx="8">
                  <c:v>63.445513939504735</c:v>
                </c:pt>
                <c:pt idx="9">
                  <c:v>38.487683384647369</c:v>
                </c:pt>
                <c:pt idx="10">
                  <c:v>37.729022976837861</c:v>
                </c:pt>
                <c:pt idx="11">
                  <c:v>37.0446963425910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D1-1E42-AF6E-548BAA551D33}"/>
            </c:ext>
          </c:extLst>
        </c:ser>
        <c:ser>
          <c:idx val="1"/>
          <c:order val="1"/>
          <c:tx>
            <c:strRef>
              <c:f>'Summary Printout'!$AC$103</c:f>
              <c:strCache>
                <c:ptCount val="1"/>
                <c:pt idx="0">
                  <c:v>Group 2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S$104:$AS$115</c:f>
                <c:numCache>
                  <c:formatCode>General</c:formatCode>
                  <c:ptCount val="12"/>
                  <c:pt idx="0">
                    <c:v>3.296543579281046</c:v>
                  </c:pt>
                  <c:pt idx="1">
                    <c:v>3.1053843930827778</c:v>
                  </c:pt>
                  <c:pt idx="2">
                    <c:v>3.0696113518271355</c:v>
                  </c:pt>
                  <c:pt idx="3">
                    <c:v>2.814615689759234</c:v>
                  </c:pt>
                  <c:pt idx="4">
                    <c:v>2.7798489915699096</c:v>
                  </c:pt>
                  <c:pt idx="5">
                    <c:v>2.7808209007180444</c:v>
                  </c:pt>
                  <c:pt idx="6">
                    <c:v>3.2516875664218619</c:v>
                  </c:pt>
                  <c:pt idx="7">
                    <c:v>3.2940028824795728</c:v>
                  </c:pt>
                  <c:pt idx="8">
                    <c:v>3.3505679069230867</c:v>
                  </c:pt>
                  <c:pt idx="9">
                    <c:v>2.6319769815962499</c:v>
                  </c:pt>
                  <c:pt idx="10">
                    <c:v>2.5486031442409574</c:v>
                  </c:pt>
                  <c:pt idx="11">
                    <c:v>2.5424218172965083</c:v>
                  </c:pt>
                </c:numCache>
              </c:numRef>
            </c:plus>
            <c:minus>
              <c:numRef>
                <c:f>'Summary Printout'!$AS$104:$AS$115</c:f>
                <c:numCache>
                  <c:formatCode>General</c:formatCode>
                  <c:ptCount val="12"/>
                  <c:pt idx="0">
                    <c:v>3.296543579281046</c:v>
                  </c:pt>
                  <c:pt idx="1">
                    <c:v>3.1053843930827778</c:v>
                  </c:pt>
                  <c:pt idx="2">
                    <c:v>3.0696113518271355</c:v>
                  </c:pt>
                  <c:pt idx="3">
                    <c:v>2.814615689759234</c:v>
                  </c:pt>
                  <c:pt idx="4">
                    <c:v>2.7798489915699096</c:v>
                  </c:pt>
                  <c:pt idx="5">
                    <c:v>2.7808209007180444</c:v>
                  </c:pt>
                  <c:pt idx="6">
                    <c:v>3.2516875664218619</c:v>
                  </c:pt>
                  <c:pt idx="7">
                    <c:v>3.2940028824795728</c:v>
                  </c:pt>
                  <c:pt idx="8">
                    <c:v>3.3505679069230867</c:v>
                  </c:pt>
                  <c:pt idx="9">
                    <c:v>2.6319769815962499</c:v>
                  </c:pt>
                  <c:pt idx="10">
                    <c:v>2.5486031442409574</c:v>
                  </c:pt>
                  <c:pt idx="11">
                    <c:v>2.5424218172965083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C$104:$AC$115</c:f>
              <c:numCache>
                <c:formatCode>0.0</c:formatCode>
                <c:ptCount val="12"/>
                <c:pt idx="0">
                  <c:v>87.886190572523731</c:v>
                </c:pt>
                <c:pt idx="1">
                  <c:v>81.009901670183936</c:v>
                </c:pt>
                <c:pt idx="2">
                  <c:v>79.09995093627289</c:v>
                </c:pt>
                <c:pt idx="3">
                  <c:v>64.891359298631187</c:v>
                </c:pt>
                <c:pt idx="4">
                  <c:v>64.097920451917574</c:v>
                </c:pt>
                <c:pt idx="5">
                  <c:v>62.99110996285544</c:v>
                </c:pt>
                <c:pt idx="6">
                  <c:v>73.789606889128962</c:v>
                </c:pt>
                <c:pt idx="7">
                  <c:v>73.774849857350588</c:v>
                </c:pt>
                <c:pt idx="8">
                  <c:v>72.579543391219303</c:v>
                </c:pt>
                <c:pt idx="9">
                  <c:v>41.994977597697542</c:v>
                </c:pt>
                <c:pt idx="10">
                  <c:v>40.89994925117626</c:v>
                </c:pt>
                <c:pt idx="11">
                  <c:v>40.1429971008501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D1-1E42-AF6E-548BAA551D33}"/>
            </c:ext>
          </c:extLst>
        </c:ser>
        <c:ser>
          <c:idx val="2"/>
          <c:order val="2"/>
          <c:tx>
            <c:strRef>
              <c:f>'Summary Printout'!$AD$103</c:f>
              <c:strCache>
                <c:ptCount val="1"/>
                <c:pt idx="0">
                  <c:v>Group 3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T$104:$AT$115</c:f>
                <c:numCache>
                  <c:formatCode>General</c:formatCode>
                  <c:ptCount val="12"/>
                  <c:pt idx="0">
                    <c:v>2.0561512599948073</c:v>
                  </c:pt>
                  <c:pt idx="1">
                    <c:v>1.7902910239109204</c:v>
                  </c:pt>
                  <c:pt idx="2">
                    <c:v>1.7499558361406775</c:v>
                  </c:pt>
                  <c:pt idx="3">
                    <c:v>1.3279493524690837</c:v>
                  </c:pt>
                  <c:pt idx="4">
                    <c:v>1.2885322316639569</c:v>
                  </c:pt>
                  <c:pt idx="5">
                    <c:v>1.2592192820125547</c:v>
                  </c:pt>
                  <c:pt idx="6">
                    <c:v>2.0252010999995598</c:v>
                  </c:pt>
                  <c:pt idx="7">
                    <c:v>2.1011601962020898</c:v>
                  </c:pt>
                  <c:pt idx="8">
                    <c:v>2.0607071817804075</c:v>
                  </c:pt>
                  <c:pt idx="9">
                    <c:v>0.87055174775936506</c:v>
                  </c:pt>
                  <c:pt idx="10">
                    <c:v>0.87216445643298501</c:v>
                  </c:pt>
                  <c:pt idx="11">
                    <c:v>0.90811590215330884</c:v>
                  </c:pt>
                </c:numCache>
              </c:numRef>
            </c:plus>
            <c:minus>
              <c:numRef>
                <c:f>'Summary Printout'!$AT$104:$AT$115</c:f>
                <c:numCache>
                  <c:formatCode>General</c:formatCode>
                  <c:ptCount val="12"/>
                  <c:pt idx="0">
                    <c:v>2.0561512599948073</c:v>
                  </c:pt>
                  <c:pt idx="1">
                    <c:v>1.7902910239109204</c:v>
                  </c:pt>
                  <c:pt idx="2">
                    <c:v>1.7499558361406775</c:v>
                  </c:pt>
                  <c:pt idx="3">
                    <c:v>1.3279493524690837</c:v>
                  </c:pt>
                  <c:pt idx="4">
                    <c:v>1.2885322316639569</c:v>
                  </c:pt>
                  <c:pt idx="5">
                    <c:v>1.2592192820125547</c:v>
                  </c:pt>
                  <c:pt idx="6">
                    <c:v>2.0252010999995598</c:v>
                  </c:pt>
                  <c:pt idx="7">
                    <c:v>2.1011601962020898</c:v>
                  </c:pt>
                  <c:pt idx="8">
                    <c:v>2.0607071817804075</c:v>
                  </c:pt>
                  <c:pt idx="9">
                    <c:v>0.87055174775936506</c:v>
                  </c:pt>
                  <c:pt idx="10">
                    <c:v>0.87216445643298501</c:v>
                  </c:pt>
                  <c:pt idx="11">
                    <c:v>0.9081159021533088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D$104:$AD$115</c:f>
              <c:numCache>
                <c:formatCode>0.0</c:formatCode>
                <c:ptCount val="12"/>
                <c:pt idx="0">
                  <c:v>69.555461235021411</c:v>
                </c:pt>
                <c:pt idx="1">
                  <c:v>63.904221798881309</c:v>
                </c:pt>
                <c:pt idx="2">
                  <c:v>62.201387001290954</c:v>
                </c:pt>
                <c:pt idx="3">
                  <c:v>51.912096578099749</c:v>
                </c:pt>
                <c:pt idx="4">
                  <c:v>51.111307024683228</c:v>
                </c:pt>
                <c:pt idx="5">
                  <c:v>50.082322738043267</c:v>
                </c:pt>
                <c:pt idx="6">
                  <c:v>58.314120148493572</c:v>
                </c:pt>
                <c:pt idx="7">
                  <c:v>57.783927635600584</c:v>
                </c:pt>
                <c:pt idx="8">
                  <c:v>56.663664897907438</c:v>
                </c:pt>
                <c:pt idx="9">
                  <c:v>36.302405201701966</c:v>
                </c:pt>
                <c:pt idx="10">
                  <c:v>34.810713672839732</c:v>
                </c:pt>
                <c:pt idx="11">
                  <c:v>34.2287094347481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0D1-1E42-AF6E-548BAA551D33}"/>
            </c:ext>
          </c:extLst>
        </c:ser>
        <c:ser>
          <c:idx val="3"/>
          <c:order val="3"/>
          <c:tx>
            <c:strRef>
              <c:f>'Summary Printout'!$AE$103</c:f>
              <c:strCache>
                <c:ptCount val="1"/>
                <c:pt idx="0">
                  <c:v>Group 4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U$104:$AU$115</c:f>
                <c:numCache>
                  <c:formatCode>General</c:formatCode>
                  <c:ptCount val="12"/>
                  <c:pt idx="0">
                    <c:v>1.7724146598964523</c:v>
                  </c:pt>
                  <c:pt idx="1">
                    <c:v>1.7226828222783317</c:v>
                  </c:pt>
                  <c:pt idx="2">
                    <c:v>1.6583834419301</c:v>
                  </c:pt>
                  <c:pt idx="3">
                    <c:v>1.1331853646682055</c:v>
                  </c:pt>
                  <c:pt idx="4">
                    <c:v>1.1770541415648652</c:v>
                  </c:pt>
                  <c:pt idx="5">
                    <c:v>1.1697442004345928</c:v>
                  </c:pt>
                  <c:pt idx="6">
                    <c:v>2.226143548765215</c:v>
                  </c:pt>
                  <c:pt idx="7">
                    <c:v>2.2019103439961825</c:v>
                  </c:pt>
                  <c:pt idx="8">
                    <c:v>2.2001653823451752</c:v>
                  </c:pt>
                  <c:pt idx="9">
                    <c:v>0.851239980526456</c:v>
                  </c:pt>
                  <c:pt idx="10">
                    <c:v>0.91422309641547528</c:v>
                  </c:pt>
                  <c:pt idx="11">
                    <c:v>0.93142361077485614</c:v>
                  </c:pt>
                </c:numCache>
              </c:numRef>
            </c:plus>
            <c:minus>
              <c:numRef>
                <c:f>'Summary Printout'!$AU$104:$AU$115</c:f>
                <c:numCache>
                  <c:formatCode>General</c:formatCode>
                  <c:ptCount val="12"/>
                  <c:pt idx="0">
                    <c:v>1.7724146598964523</c:v>
                  </c:pt>
                  <c:pt idx="1">
                    <c:v>1.7226828222783317</c:v>
                  </c:pt>
                  <c:pt idx="2">
                    <c:v>1.6583834419301</c:v>
                  </c:pt>
                  <c:pt idx="3">
                    <c:v>1.1331853646682055</c:v>
                  </c:pt>
                  <c:pt idx="4">
                    <c:v>1.1770541415648652</c:v>
                  </c:pt>
                  <c:pt idx="5">
                    <c:v>1.1697442004345928</c:v>
                  </c:pt>
                  <c:pt idx="6">
                    <c:v>2.226143548765215</c:v>
                  </c:pt>
                  <c:pt idx="7">
                    <c:v>2.2019103439961825</c:v>
                  </c:pt>
                  <c:pt idx="8">
                    <c:v>2.2001653823451752</c:v>
                  </c:pt>
                  <c:pt idx="9">
                    <c:v>0.851239980526456</c:v>
                  </c:pt>
                  <c:pt idx="10">
                    <c:v>0.91422309641547528</c:v>
                  </c:pt>
                  <c:pt idx="11">
                    <c:v>0.9314236107748561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E$104:$AE$115</c:f>
              <c:numCache>
                <c:formatCode>0.0</c:formatCode>
                <c:ptCount val="12"/>
                <c:pt idx="0">
                  <c:v>54.740502909261401</c:v>
                </c:pt>
                <c:pt idx="1">
                  <c:v>50.910464820048965</c:v>
                </c:pt>
                <c:pt idx="2">
                  <c:v>50.091675616788358</c:v>
                </c:pt>
                <c:pt idx="3">
                  <c:v>42.788674952861385</c:v>
                </c:pt>
                <c:pt idx="4">
                  <c:v>42.341930295535093</c:v>
                </c:pt>
                <c:pt idx="5">
                  <c:v>41.413376118260004</c:v>
                </c:pt>
                <c:pt idx="6">
                  <c:v>47.84313053708658</c:v>
                </c:pt>
                <c:pt idx="7">
                  <c:v>46.754869449035546</c:v>
                </c:pt>
                <c:pt idx="8">
                  <c:v>45.955000451029576</c:v>
                </c:pt>
                <c:pt idx="9">
                  <c:v>30.03531527953448</c:v>
                </c:pt>
                <c:pt idx="10">
                  <c:v>29.192492732374017</c:v>
                </c:pt>
                <c:pt idx="11">
                  <c:v>28.386597246548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0D1-1E42-AF6E-548BAA551D33}"/>
            </c:ext>
          </c:extLst>
        </c:ser>
        <c:ser>
          <c:idx val="4"/>
          <c:order val="4"/>
          <c:tx>
            <c:strRef>
              <c:f>'Summary Printout'!$AF$103</c:f>
              <c:strCache>
                <c:ptCount val="1"/>
                <c:pt idx="0">
                  <c:v>Group 5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V$104:$AV$115</c:f>
              </c:numRef>
            </c:plus>
            <c:minus>
              <c:numRef>
                <c:f>'Summary Printout'!$AV$104:$AV$115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F$104:$AF$115</c:f>
            </c:numRef>
          </c:yVal>
          <c:smooth val="0"/>
          <c:extLst>
            <c:ext xmlns:c16="http://schemas.microsoft.com/office/drawing/2014/chart" uri="{C3380CC4-5D6E-409C-BE32-E72D297353CC}">
              <c16:uniqueId val="{00000004-30D1-1E42-AF6E-548BAA551D33}"/>
            </c:ext>
          </c:extLst>
        </c:ser>
        <c:ser>
          <c:idx val="5"/>
          <c:order val="5"/>
          <c:tx>
            <c:strRef>
              <c:f>'Summary Printout'!$AG$103</c:f>
              <c:strCache>
                <c:ptCount val="1"/>
                <c:pt idx="0">
                  <c:v>Unselec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W$104:$AW$1048576</c:f>
              </c:numRef>
            </c:plus>
            <c:minus>
              <c:numRef>
                <c:f>'Summary Printout'!$AW$104:$AW$1048576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G$104:$AG$115</c:f>
            </c:numRef>
          </c:yVal>
          <c:smooth val="0"/>
          <c:extLst>
            <c:ext xmlns:c16="http://schemas.microsoft.com/office/drawing/2014/chart" uri="{C3380CC4-5D6E-409C-BE32-E72D297353CC}">
              <c16:uniqueId val="{00000005-30D1-1E42-AF6E-548BAA551D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815872"/>
        <c:axId val="192818176"/>
      </c:scatterChart>
      <c:valAx>
        <c:axId val="192815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92818176"/>
        <c:crosses val="autoZero"/>
        <c:crossBetween val="midCat"/>
      </c:valAx>
      <c:valAx>
        <c:axId val="192818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CR (pmol/min)</a:t>
                </a:r>
              </a:p>
            </c:rich>
          </c:tx>
          <c:layout/>
          <c:overlay val="0"/>
        </c:title>
        <c:numFmt formatCode="#0.0" sourceLinked="0"/>
        <c:majorTickMark val="out"/>
        <c:minorTickMark val="none"/>
        <c:tickLblPos val="nextTo"/>
        <c:crossAx val="19281587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aseline="0"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mmary Printout'!$CA$41</c:f>
              <c:strCache>
                <c:ptCount val="1"/>
                <c:pt idx="0">
                  <c:v>Group 1</c:v>
                </c:pt>
              </c:strCache>
            </c:strRef>
          </c:tx>
          <c:spPr>
            <a:solidFill>
              <a:srgbClr val="0070C0"/>
            </a:solidFill>
            <a:ln w="25400">
              <a:solidFill>
                <a:schemeClr val="tx1"/>
              </a:solidFill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 w="25400">
                <a:solidFill>
                  <a:schemeClr val="tx1"/>
                </a:solidFill>
              </a:ln>
              <a:effectLst/>
              <a:scene3d>
                <a:camera prst="orthographicFront"/>
                <a:lightRig rig="threePt" dir="t">
                  <a:rot lat="0" lon="0" rev="0"/>
                </a:lightRig>
              </a:scene3d>
              <a:sp3d/>
            </c:spPr>
            <c:extLst>
              <c:ext xmlns:c16="http://schemas.microsoft.com/office/drawing/2014/chart" uri="{C3380CC4-5D6E-409C-BE32-E72D297353CC}">
                <c16:uniqueId val="{00000000-C4F6-4654-8C93-638ECD550FCC}"/>
              </c:ext>
            </c:extLst>
          </c:dPt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1,'Summary Printout'!$CL$41)</c:f>
              <c:numCache>
                <c:formatCode>#0.00</c:formatCode>
                <c:ptCount val="2"/>
                <c:pt idx="0">
                  <c:v>18.101961135864258</c:v>
                </c:pt>
                <c:pt idx="1">
                  <c:v>13.542154312133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A5-6248-8FFA-4B4D799C9FB0}"/>
            </c:ext>
          </c:extLst>
        </c:ser>
        <c:ser>
          <c:idx val="1"/>
          <c:order val="1"/>
          <c:tx>
            <c:strRef>
              <c:f>'Summary Printout'!$CA$42</c:f>
              <c:strCache>
                <c:ptCount val="1"/>
                <c:pt idx="0">
                  <c:v>Group 2</c:v>
                </c:pt>
              </c:strCache>
            </c:strRef>
          </c:tx>
          <c:spPr>
            <a:solidFill>
              <a:schemeClr val="accent2"/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1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1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2,'Summary Printout'!$CL$42)</c:f>
              <c:numCache>
                <c:formatCode>#0.00</c:formatCode>
                <c:ptCount val="2"/>
                <c:pt idx="0">
                  <c:v>22.848114013671875</c:v>
                </c:pt>
                <c:pt idx="1">
                  <c:v>16.1088409423828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A5-6248-8FFA-4B4D799C9FB0}"/>
            </c:ext>
          </c:extLst>
        </c:ser>
        <c:ser>
          <c:idx val="2"/>
          <c:order val="2"/>
          <c:tx>
            <c:strRef>
              <c:f>'Summary Printout'!$CA$43</c:f>
              <c:strCache>
                <c:ptCount val="1"/>
                <c:pt idx="0">
                  <c:v>Group 3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3,'Summary Printout'!$CL$43)</c:f>
              <c:numCache>
                <c:formatCode>#0.00</c:formatCode>
                <c:ptCount val="2"/>
                <c:pt idx="0">
                  <c:v>15.853611946105957</c:v>
                </c:pt>
                <c:pt idx="1">
                  <c:v>12.119064331054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A5-6248-8FFA-4B4D799C9FB0}"/>
            </c:ext>
          </c:extLst>
        </c:ser>
        <c:ser>
          <c:idx val="3"/>
          <c:order val="3"/>
          <c:tx>
            <c:strRef>
              <c:f>'Summary Printout'!$CA$44</c:f>
              <c:strCache>
                <c:ptCount val="1"/>
                <c:pt idx="0">
                  <c:v>Group 4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4,'Summary Printout'!$CL$44)</c:f>
              <c:numCache>
                <c:formatCode>#0.00</c:formatCode>
                <c:ptCount val="2"/>
                <c:pt idx="0">
                  <c:v>13.026777267456055</c:v>
                </c:pt>
                <c:pt idx="1">
                  <c:v>8.6782999038696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A5-6248-8FFA-4B4D799C9F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9660544"/>
        <c:axId val="189924480"/>
      </c:barChart>
      <c:catAx>
        <c:axId val="189660544"/>
        <c:scaling>
          <c:orientation val="minMax"/>
        </c:scaling>
        <c:delete val="0"/>
        <c:axPos val="b"/>
        <c:numFmt formatCode="#0.0" sourceLinked="0"/>
        <c:majorTickMark val="none"/>
        <c:minorTickMark val="none"/>
        <c:tickLblPos val="nextTo"/>
        <c:txPr>
          <a:bodyPr rot="0" vert="horz"/>
          <a:lstStyle/>
          <a:p>
            <a:pPr>
              <a:defRPr lang="en-US" sz="1100" b="0"/>
            </a:pPr>
            <a:endParaRPr lang="en-US"/>
          </a:p>
        </c:txPr>
        <c:crossAx val="189924480"/>
        <c:crosses val="autoZero"/>
        <c:auto val="1"/>
        <c:lblAlgn val="ctr"/>
        <c:lblOffset val="100"/>
        <c:noMultiLvlLbl val="0"/>
      </c:catAx>
      <c:valAx>
        <c:axId val="189924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OCR (pmol/min)</a:t>
                </a:r>
              </a:p>
            </c:rich>
          </c:tx>
          <c:layout/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89660544"/>
        <c:crosses val="autoZero"/>
        <c:crossBetween val="between"/>
      </c:valAx>
      <c:spPr>
        <a:effectLst/>
      </c:spPr>
    </c:plotArea>
    <c:plotVisOnly val="0"/>
    <c:dispBlanksAs val="gap"/>
    <c:showDLblsOverMax val="0"/>
  </c:chart>
  <c:spPr>
    <a:solidFill>
      <a:schemeClr val="bg1"/>
    </a:solidFill>
    <a:ln w="25400">
      <a:solidFill>
        <a:schemeClr val="tx1"/>
      </a:solidFill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IN" sz="1800"/>
            </a:pPr>
            <a:r>
              <a:rPr lang="en-US" sz="1800" b="1" i="0" baseline="0">
                <a:effectLst/>
              </a:rPr>
              <a:t>Oxygen Consumption Rate</a:t>
            </a:r>
            <a:endParaRPr lang="en-IN" sz="1800">
              <a:effectLst/>
            </a:endParaRPr>
          </a:p>
        </c:rich>
      </c:tx>
      <c:layout>
        <c:manualLayout>
          <c:xMode val="edge"/>
          <c:yMode val="edge"/>
          <c:x val="0.26922523106176749"/>
          <c:y val="3.5381381063270059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2718449283007738"/>
          <c:y val="0.15639460229068325"/>
          <c:w val="0.70009436782529877"/>
          <c:h val="0.55465820432959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Printout'!$HA$61</c:f>
              <c:strCache>
                <c:ptCount val="1"/>
                <c:pt idx="0">
                  <c:v>Group 1</c:v>
                </c:pt>
              </c:strCache>
            </c:strRef>
          </c:tx>
          <c:spPr>
            <a:solidFill>
              <a:srgbClr val="4A7EBB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minus>
          </c:errBars>
          <c:cat>
            <c:strLit>
              <c:ptCount val="2"/>
              <c:pt idx="0">
                <c:v>Baseline</c:v>
              </c:pt>
              <c:pt idx="1">
                <c:v>Stressed</c:v>
              </c:pt>
            </c:strLit>
          </c:cat>
          <c:val>
            <c:numRef>
              <c:f>('Summary Printout'!$HB$61,'Summary Printout'!$HD$61)</c:f>
              <c:numCache>
                <c:formatCode>0.00</c:formatCode>
                <c:ptCount val="2"/>
                <c:pt idx="0">
                  <c:v>64.565528869628906</c:v>
                </c:pt>
                <c:pt idx="1">
                  <c:v>75.265495300292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15-F048-B16E-6ADA2D78D3B3}"/>
            </c:ext>
          </c:extLst>
        </c:ser>
        <c:ser>
          <c:idx val="1"/>
          <c:order val="1"/>
          <c:tx>
            <c:strRef>
              <c:f>'Summary Printout'!$HA$62</c:f>
              <c:strCache>
                <c:ptCount val="1"/>
                <c:pt idx="0">
                  <c:v>Group 2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2,'Summary Printout'!$HD$62)</c:f>
              <c:numCache>
                <c:formatCode>0.00</c:formatCode>
                <c:ptCount val="2"/>
                <c:pt idx="0">
                  <c:v>76.294036865234375</c:v>
                </c:pt>
                <c:pt idx="1">
                  <c:v>86.679374694824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15-F048-B16E-6ADA2D78D3B3}"/>
            </c:ext>
          </c:extLst>
        </c:ser>
        <c:ser>
          <c:idx val="2"/>
          <c:order val="2"/>
          <c:tx>
            <c:strRef>
              <c:f>'Summary Printout'!$HA$63</c:f>
              <c:strCache>
                <c:ptCount val="1"/>
                <c:pt idx="0">
                  <c:v>Group 3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3,'Summary Printout'!$HD$63)</c:f>
              <c:numCache>
                <c:formatCode>0.00</c:formatCode>
                <c:ptCount val="2"/>
                <c:pt idx="0">
                  <c:v>63.912593841552734</c:v>
                </c:pt>
                <c:pt idx="1">
                  <c:v>71.7542953491210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15-F048-B16E-6ADA2D78D3B3}"/>
            </c:ext>
          </c:extLst>
        </c:ser>
        <c:ser>
          <c:idx val="3"/>
          <c:order val="3"/>
          <c:tx>
            <c:strRef>
              <c:f>'Summary Printout'!$HA$64</c:f>
              <c:strCache>
                <c:ptCount val="1"/>
                <c:pt idx="0">
                  <c:v>Group 4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4,'Summary Printout'!$HD$64)</c:f>
              <c:numCache>
                <c:formatCode>0.00</c:formatCode>
                <c:ptCount val="2"/>
                <c:pt idx="0">
                  <c:v>51.145511627197266</c:v>
                </c:pt>
                <c:pt idx="1">
                  <c:v>54.249671936035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15-F048-B16E-6ADA2D78D3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578944"/>
        <c:axId val="116588928"/>
      </c:barChart>
      <c:catAx>
        <c:axId val="1165789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 sz="1600" b="1" baseline="0">
                <a:latin typeface="+mn-lt"/>
              </a:defRPr>
            </a:pPr>
            <a:endParaRPr lang="en-US"/>
          </a:p>
        </c:txPr>
        <c:crossAx val="116588928"/>
        <c:crosses val="autoZero"/>
        <c:auto val="1"/>
        <c:lblAlgn val="ctr"/>
        <c:lblOffset val="100"/>
        <c:noMultiLvlLbl val="0"/>
      </c:catAx>
      <c:valAx>
        <c:axId val="1165889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IN" sz="1600"/>
                </a:pPr>
                <a:r>
                  <a:rPr lang="en-IN" sz="1600"/>
                  <a:t>OCR (pmol/min)</a:t>
                </a:r>
              </a:p>
            </c:rich>
          </c:tx>
          <c:layout>
            <c:manualLayout>
              <c:xMode val="edge"/>
              <c:yMode val="edge"/>
              <c:x val="3.571183147552149E-2"/>
              <c:y val="0.26674542205421758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200" b="0"/>
            </a:pPr>
            <a:endParaRPr lang="en-US"/>
          </a:p>
        </c:txPr>
        <c:crossAx val="116578944"/>
        <c:crosses val="autoZero"/>
        <c:crossBetween val="between"/>
      </c:valAx>
      <c:spPr>
        <a:ln w="9525">
          <a:solidFill>
            <a:schemeClr val="bg1">
              <a:lumMod val="65000"/>
            </a:schemeClr>
          </a:solidFill>
        </a:ln>
        <a:effectLst/>
      </c:spPr>
    </c:plotArea>
    <c:plotVisOnly val="0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IN"/>
            </a:pPr>
            <a:r>
              <a:rPr lang="en-IN"/>
              <a:t>XF Cell Energy Phenotype</a:t>
            </a:r>
          </a:p>
        </c:rich>
      </c:tx>
      <c:layout>
        <c:manualLayout>
          <c:xMode val="edge"/>
          <c:yMode val="edge"/>
          <c:x val="0.26676283610960549"/>
          <c:y val="1.595214523904876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2536413410150241"/>
          <c:y val="0.13027254278328074"/>
          <c:w val="0.63218980169023276"/>
          <c:h val="0.49481860856896648"/>
        </c:manualLayout>
      </c:layout>
      <c:scatterChart>
        <c:scatterStyle val="smoothMarker"/>
        <c:varyColors val="0"/>
        <c:ser>
          <c:idx val="0"/>
          <c:order val="0"/>
          <c:tx>
            <c:v>Group 1</c:v>
          </c:tx>
          <c:spPr>
            <a:ln w="15875">
              <a:solidFill>
                <a:srgbClr val="416FA6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416FA6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1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1:$IH$61</c:f>
                <c:numCache>
                  <c:formatCode>General</c:formatCode>
                  <c:ptCount val="2"/>
                  <c:pt idx="0">
                    <c:v>2.5209152698516846</c:v>
                  </c:pt>
                  <c:pt idx="1">
                    <c:v>3.25937819480896</c:v>
                  </c:pt>
                </c:numCache>
              </c:numRef>
            </c:plus>
            <c:minus>
              <c:numRef>
                <c:f>'Summary Printout'!$IG$61:$IH$61</c:f>
                <c:numCache>
                  <c:formatCode>General</c:formatCode>
                  <c:ptCount val="2"/>
                  <c:pt idx="0">
                    <c:v>2.5209152698516846</c:v>
                  </c:pt>
                  <c:pt idx="1">
                    <c:v>3.25937819480896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1:$IF$61</c:f>
                <c:numCache>
                  <c:formatCode>General</c:formatCode>
                  <c:ptCount val="2"/>
                  <c:pt idx="0">
                    <c:v>1.4935623407363892</c:v>
                  </c:pt>
                  <c:pt idx="1">
                    <c:v>1.782351016998291</c:v>
                  </c:pt>
                </c:numCache>
              </c:numRef>
            </c:plus>
            <c:minus>
              <c:numRef>
                <c:f>'Summary Printout'!$IE$61:$IF$61</c:f>
                <c:numCache>
                  <c:formatCode>General</c:formatCode>
                  <c:ptCount val="2"/>
                  <c:pt idx="0">
                    <c:v>1.4935623407363892</c:v>
                  </c:pt>
                  <c:pt idx="1">
                    <c:v>1.782351016998291</c:v>
                  </c:pt>
                </c:numCache>
              </c:numRef>
            </c:minus>
          </c:errBars>
          <c:xVal>
            <c:numRef>
              <c:f>'Summary Printout'!$IA$61:$IB$61</c:f>
              <c:numCache>
                <c:formatCode>0.00</c:formatCode>
                <c:ptCount val="2"/>
                <c:pt idx="0">
                  <c:v>28.084053039550781</c:v>
                </c:pt>
                <c:pt idx="1">
                  <c:v>40.865055084228516</c:v>
                </c:pt>
              </c:numCache>
            </c:numRef>
          </c:xVal>
          <c:yVal>
            <c:numRef>
              <c:f>'Summary Printout'!$IC$61:$ID$61</c:f>
              <c:numCache>
                <c:formatCode>0.00</c:formatCode>
                <c:ptCount val="2"/>
                <c:pt idx="0">
                  <c:v>66.861442565917969</c:v>
                </c:pt>
                <c:pt idx="1">
                  <c:v>77.9321441650390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264-F24B-9A1C-C0F9597E0A9F}"/>
            </c:ext>
          </c:extLst>
        </c:ser>
        <c:ser>
          <c:idx val="1"/>
          <c:order val="1"/>
          <c:tx>
            <c:v>Group 2</c:v>
          </c:tx>
          <c:spPr>
            <a:ln w="15875">
              <a:solidFill>
                <a:srgbClr val="A8423F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A8423F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4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2:$IH$62</c:f>
                <c:numCache>
                  <c:formatCode>General</c:formatCode>
                  <c:ptCount val="2"/>
                  <c:pt idx="0">
                    <c:v>1.9723794460296631</c:v>
                  </c:pt>
                  <c:pt idx="1">
                    <c:v>2.830371618270874</c:v>
                  </c:pt>
                </c:numCache>
              </c:numRef>
            </c:plus>
            <c:minus>
              <c:numRef>
                <c:f>'Summary Printout'!$IG$62:$IH$62</c:f>
                <c:numCache>
                  <c:formatCode>General</c:formatCode>
                  <c:ptCount val="2"/>
                  <c:pt idx="0">
                    <c:v>1.9723794460296631</c:v>
                  </c:pt>
                  <c:pt idx="1">
                    <c:v>2.830371618270874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2:$IF$62</c:f>
                <c:numCache>
                  <c:formatCode>General</c:formatCode>
                  <c:ptCount val="2"/>
                  <c:pt idx="0">
                    <c:v>1.2529850006103516</c:v>
                  </c:pt>
                  <c:pt idx="1">
                    <c:v>1.6322178840637207</c:v>
                  </c:pt>
                </c:numCache>
              </c:numRef>
            </c:plus>
            <c:minus>
              <c:numRef>
                <c:f>'Summary Printout'!$IE$62:$IF$62</c:f>
                <c:numCache>
                  <c:formatCode>General</c:formatCode>
                  <c:ptCount val="2"/>
                  <c:pt idx="0">
                    <c:v>1.2529850006103516</c:v>
                  </c:pt>
                  <c:pt idx="1">
                    <c:v>1.6322178840637207</c:v>
                  </c:pt>
                </c:numCache>
              </c:numRef>
            </c:minus>
          </c:errBars>
          <c:xVal>
            <c:numRef>
              <c:f>'Summary Printout'!$IA$62:$IB$62</c:f>
              <c:numCache>
                <c:formatCode>0.00</c:formatCode>
                <c:ptCount val="2"/>
                <c:pt idx="0">
                  <c:v>31.691213607788086</c:v>
                </c:pt>
                <c:pt idx="1">
                  <c:v>44.149929046630859</c:v>
                </c:pt>
              </c:numCache>
            </c:numRef>
          </c:xVal>
          <c:yVal>
            <c:numRef>
              <c:f>'Summary Printout'!$IC$62:$ID$62</c:f>
              <c:numCache>
                <c:formatCode>0.00</c:formatCode>
                <c:ptCount val="2"/>
                <c:pt idx="0">
                  <c:v>76.294036865234375</c:v>
                </c:pt>
                <c:pt idx="1">
                  <c:v>86.6793746948242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264-F24B-9A1C-C0F9597E0A9F}"/>
            </c:ext>
          </c:extLst>
        </c:ser>
        <c:ser>
          <c:idx val="2"/>
          <c:order val="2"/>
          <c:tx>
            <c:v>Group 3</c:v>
          </c:tx>
          <c:spPr>
            <a:ln w="15875">
              <a:solidFill>
                <a:srgbClr val="86A44A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86A44A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7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3:$IH$63</c:f>
                <c:numCache>
                  <c:formatCode>General</c:formatCode>
                  <c:ptCount val="2"/>
                  <c:pt idx="0">
                    <c:v>2.3318793773651123</c:v>
                  </c:pt>
                  <c:pt idx="1">
                    <c:v>3.1506557464599609</c:v>
                  </c:pt>
                </c:numCache>
              </c:numRef>
            </c:plus>
            <c:minus>
              <c:numRef>
                <c:f>'Summary Printout'!$IG$63:$IH$63</c:f>
                <c:numCache>
                  <c:formatCode>General</c:formatCode>
                  <c:ptCount val="2"/>
                  <c:pt idx="0">
                    <c:v>2.3318793773651123</c:v>
                  </c:pt>
                  <c:pt idx="1">
                    <c:v>3.1506557464599609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3:$IF$63</c:f>
                <c:numCache>
                  <c:formatCode>General</c:formatCode>
                  <c:ptCount val="2"/>
                  <c:pt idx="0">
                    <c:v>1.4771171808242798</c:v>
                  </c:pt>
                  <c:pt idx="1">
                    <c:v>1.8196297883987427</c:v>
                  </c:pt>
                </c:numCache>
              </c:numRef>
            </c:plus>
            <c:minus>
              <c:numRef>
                <c:f>'Summary Printout'!$IE$63:$IF$63</c:f>
                <c:numCache>
                  <c:formatCode>General</c:formatCode>
                  <c:ptCount val="2"/>
                  <c:pt idx="0">
                    <c:v>1.4771171808242798</c:v>
                  </c:pt>
                  <c:pt idx="1">
                    <c:v>1.8196297883987427</c:v>
                  </c:pt>
                </c:numCache>
              </c:numRef>
            </c:minus>
          </c:errBars>
          <c:xVal>
            <c:numRef>
              <c:f>'Summary Printout'!$IA$63:$IB$63</c:f>
              <c:numCache>
                <c:formatCode>0.00</c:formatCode>
                <c:ptCount val="2"/>
                <c:pt idx="0">
                  <c:v>19.889570236206055</c:v>
                </c:pt>
                <c:pt idx="1">
                  <c:v>31.217006683349609</c:v>
                </c:pt>
              </c:numCache>
            </c:numRef>
          </c:xVal>
          <c:yVal>
            <c:numRef>
              <c:f>'Summary Printout'!$IC$63:$ID$63</c:f>
              <c:numCache>
                <c:formatCode>0.00</c:formatCode>
                <c:ptCount val="2"/>
                <c:pt idx="0">
                  <c:v>60.223232269287109</c:v>
                </c:pt>
                <c:pt idx="1">
                  <c:v>66.8423385620117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5264-F24B-9A1C-C0F9597E0A9F}"/>
            </c:ext>
          </c:extLst>
        </c:ser>
        <c:ser>
          <c:idx val="3"/>
          <c:order val="3"/>
          <c:tx>
            <c:v>Group 4</c:v>
          </c:tx>
          <c:spPr>
            <a:ln w="15875">
              <a:solidFill>
                <a:srgbClr val="6E548D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6E548D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A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4:$IH$64</c:f>
                <c:numCache>
                  <c:formatCode>General</c:formatCode>
                  <c:ptCount val="2"/>
                  <c:pt idx="0">
                    <c:v>2.3952677249908447</c:v>
                  </c:pt>
                  <c:pt idx="1">
                    <c:v>3.0706274509429932</c:v>
                  </c:pt>
                </c:numCache>
              </c:numRef>
            </c:plus>
            <c:minus>
              <c:numRef>
                <c:f>'Summary Printout'!$IG$64:$IH$64</c:f>
                <c:numCache>
                  <c:formatCode>General</c:formatCode>
                  <c:ptCount val="2"/>
                  <c:pt idx="0">
                    <c:v>2.3952677249908447</c:v>
                  </c:pt>
                  <c:pt idx="1">
                    <c:v>3.0706274509429932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4:$IF$64</c:f>
                <c:numCache>
                  <c:formatCode>General</c:formatCode>
                  <c:ptCount val="2"/>
                  <c:pt idx="0">
                    <c:v>1.5911328792572021</c:v>
                  </c:pt>
                  <c:pt idx="1">
                    <c:v>2.1370987892150879</c:v>
                  </c:pt>
                </c:numCache>
              </c:numRef>
            </c:plus>
            <c:minus>
              <c:numRef>
                <c:f>'Summary Printout'!$IE$64:$IF$64</c:f>
                <c:numCache>
                  <c:formatCode>General</c:formatCode>
                  <c:ptCount val="2"/>
                  <c:pt idx="0">
                    <c:v>1.5911328792572021</c:v>
                  </c:pt>
                  <c:pt idx="1">
                    <c:v>2.1370987892150879</c:v>
                  </c:pt>
                </c:numCache>
              </c:numRef>
            </c:minus>
          </c:errBars>
          <c:xVal>
            <c:numRef>
              <c:f>'Summary Printout'!$IA$64:$IB$64</c:f>
              <c:numCache>
                <c:formatCode>0.00</c:formatCode>
                <c:ptCount val="2"/>
                <c:pt idx="0">
                  <c:v>16.963005065917969</c:v>
                </c:pt>
                <c:pt idx="1">
                  <c:v>23.63050651550293</c:v>
                </c:pt>
              </c:numCache>
            </c:numRef>
          </c:xVal>
          <c:yVal>
            <c:numRef>
              <c:f>'Summary Printout'!$IC$64:$ID$64</c:f>
              <c:numCache>
                <c:formatCode>0.00</c:formatCode>
                <c:ptCount val="2"/>
                <c:pt idx="0">
                  <c:v>47.826614379882813</c:v>
                </c:pt>
                <c:pt idx="1">
                  <c:v>50.4389801025390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5264-F24B-9A1C-C0F9597E0A9F}"/>
            </c:ext>
          </c:extLst>
        </c:ser>
        <c:ser>
          <c:idx val="4"/>
          <c:order val="4"/>
          <c:tx>
            <c:v/>
          </c:tx>
          <c:spPr>
            <a:ln w="15875">
              <a:solidFill>
                <a:srgbClr val="000000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000000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D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5:$IH$65</c:f>
                <c:numCache>
                  <c:formatCode>General</c:formatCode>
                  <c:ptCount val="2"/>
                </c:numCache>
              </c:numRef>
            </c:plus>
            <c:minus>
              <c:numRef>
                <c:f>'Summary Printout'!$IG$65:$IH$65</c:f>
                <c:numCache>
                  <c:formatCode>General</c:formatCode>
                  <c:ptCount val="2"/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5:$IF$65</c:f>
                <c:numCache>
                  <c:formatCode>General</c:formatCode>
                  <c:ptCount val="2"/>
                </c:numCache>
              </c:numRef>
            </c:plus>
            <c:minus>
              <c:numRef>
                <c:f>'Summary Printout'!$IE$65:$IF$65</c:f>
                <c:numCache>
                  <c:formatCode>General</c:formatCode>
                  <c:ptCount val="2"/>
                </c:numCache>
              </c:numRef>
            </c:minus>
          </c:errBars>
          <c:xVal>
            <c:numRef>
              <c:f>'Summary Printout'!$IA$65:$IB$65</c:f>
              <c:numCache>
                <c:formatCode>General</c:formatCode>
                <c:ptCount val="2"/>
              </c:numCache>
            </c:numRef>
          </c:xVal>
          <c:yVal>
            <c:numRef>
              <c:f>'Summary Printout'!$IC$65:$ID$65</c:f>
              <c:numCache>
                <c:formatCode>General</c:formatCode>
                <c:ptCount val="2"/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5264-F24B-9A1C-C0F9597E0A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035776"/>
        <c:axId val="117037696"/>
      </c:scatterChart>
      <c:valAx>
        <c:axId val="117035776"/>
        <c:scaling>
          <c:orientation val="minMax"/>
          <c:max val="95.7821469306945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en-IN" sz="1600"/>
                </a:pPr>
                <a:r>
                  <a:rPr lang="en-US" sz="1600"/>
                  <a:t>ECAR (mpH/min)
Glycolysis</a:t>
                </a:r>
              </a:p>
            </c:rich>
          </c:tx>
          <c:layout>
            <c:manualLayout>
              <c:xMode val="edge"/>
              <c:yMode val="edge"/>
              <c:x val="0.37599246880149118"/>
              <c:y val="0.66394200030489625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IN" sz="1200"/>
            </a:pPr>
            <a:endParaRPr lang="en-US"/>
          </a:p>
        </c:txPr>
        <c:crossAx val="117037696"/>
        <c:crosses val="autoZero"/>
        <c:crossBetween val="midCat"/>
      </c:valAx>
      <c:valAx>
        <c:axId val="117037696"/>
        <c:scaling>
          <c:orientation val="minMax"/>
          <c:max val="9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lang="en-IN" sz="1600"/>
                </a:pPr>
                <a:r>
                  <a:rPr lang="en-US" sz="1600"/>
                  <a:t>Mitochondrial Respiration
OCR (pmol/min)</a:t>
                </a:r>
              </a:p>
            </c:rich>
          </c:tx>
          <c:layout>
            <c:manualLayout>
              <c:xMode val="edge"/>
              <c:yMode val="edge"/>
              <c:x val="1.2389862226960988E-2"/>
              <c:y val="0.15448145907863703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IN" sz="1200"/>
            </a:pPr>
            <a:endParaRPr lang="en-US"/>
          </a:p>
        </c:txPr>
        <c:crossAx val="117035776"/>
        <c:crosses val="autoZero"/>
        <c:crossBetween val="midCat"/>
      </c:valAx>
      <c:spPr>
        <a:ln w="9525" cmpd="sng">
          <a:solidFill>
            <a:srgbClr val="A6A6A6"/>
          </a:solidFill>
          <a:prstDash val="solid"/>
        </a:ln>
      </c:spPr>
    </c:plotArea>
    <c:plotVisOnly val="0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other cells'!$E$54</c:f>
              <c:strCache>
                <c:ptCount val="1"/>
                <c:pt idx="0">
                  <c:v>scrambled 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E$58:$G$58</c:f>
                <c:numCache>
                  <c:formatCode>General</c:formatCode>
                  <c:ptCount val="3"/>
                  <c:pt idx="0">
                    <c:v>4.9999999999998657E-4</c:v>
                  </c:pt>
                  <c:pt idx="1">
                    <c:v>2.1875000000001754E-4</c:v>
                  </c:pt>
                  <c:pt idx="2">
                    <c:v>8.4374999999997646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E$55:$E$56</c:f>
              <c:numCache>
                <c:formatCode>General</c:formatCode>
                <c:ptCount val="2"/>
                <c:pt idx="0">
                  <c:v>0.12574999999999997</c:v>
                </c:pt>
                <c:pt idx="1">
                  <c:v>0.17678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0B-45E9-A867-872CC268D59B}"/>
            </c:ext>
          </c:extLst>
        </c:ser>
        <c:ser>
          <c:idx val="1"/>
          <c:order val="1"/>
          <c:tx>
            <c:strRef>
              <c:f>'other cells'!$F$54</c:f>
              <c:strCache>
                <c:ptCount val="1"/>
                <c:pt idx="0">
                  <c:v>si-circNFATc3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F$58:$F$59</c:f>
                <c:numCache>
                  <c:formatCode>General</c:formatCode>
                  <c:ptCount val="2"/>
                  <c:pt idx="0">
                    <c:v>2.1875000000001754E-4</c:v>
                  </c:pt>
                  <c:pt idx="1">
                    <c:v>1.6874999999999807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F$55:$F$56</c:f>
              <c:numCache>
                <c:formatCode>General</c:formatCode>
                <c:ptCount val="2"/>
                <c:pt idx="0">
                  <c:v>0.12728125000000001</c:v>
                </c:pt>
                <c:pt idx="1">
                  <c:v>0.174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0B-45E9-A867-872CC268D59B}"/>
            </c:ext>
          </c:extLst>
        </c:ser>
        <c:ser>
          <c:idx val="2"/>
          <c:order val="2"/>
          <c:tx>
            <c:strRef>
              <c:f>'other cells'!$G$54</c:f>
              <c:strCache>
                <c:ptCount val="1"/>
                <c:pt idx="0">
                  <c:v>si-circNFATC3-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G$58:$G$59</c:f>
                <c:numCache>
                  <c:formatCode>General</c:formatCode>
                  <c:ptCount val="2"/>
                  <c:pt idx="0">
                    <c:v>8.4374999999997646E-4</c:v>
                  </c:pt>
                  <c:pt idx="1">
                    <c:v>1.624999999999987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G$55:$G$56</c:f>
              <c:numCache>
                <c:formatCode>General</c:formatCode>
                <c:ptCount val="2"/>
                <c:pt idx="0">
                  <c:v>0.12965625</c:v>
                </c:pt>
                <c:pt idx="1">
                  <c:v>0.16724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0B-45E9-A867-872CC268D5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8325792"/>
        <c:axId val="1341102816"/>
      </c:barChart>
      <c:catAx>
        <c:axId val="1538325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41102816"/>
        <c:crosses val="autoZero"/>
        <c:auto val="1"/>
        <c:lblAlgn val="ctr"/>
        <c:lblOffset val="100"/>
        <c:noMultiLvlLbl val="0"/>
      </c:catAx>
      <c:valAx>
        <c:axId val="13411028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8325792"/>
        <c:crosses val="autoZero"/>
        <c:crossBetween val="between"/>
      </c:valAx>
      <c:spPr>
        <a:noFill/>
        <a:ln>
          <a:solidFill>
            <a:schemeClr val="bg1">
              <a:lumMod val="85000"/>
            </a:schemeClr>
          </a:solidFill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3405041725062"/>
          <c:y val="8.5856299212598422E-2"/>
          <c:w val="0.73554831152698186"/>
          <c:h val="0.609690248947264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ther cells'!$S$25</c:f>
              <c:strCache>
                <c:ptCount val="1"/>
                <c:pt idx="0">
                  <c:v>scrambled 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bg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S$28:$S$29</c:f>
                <c:numCache>
                  <c:formatCode>General</c:formatCode>
                  <c:ptCount val="2"/>
                  <c:pt idx="0">
                    <c:v>32.5</c:v>
                  </c:pt>
                  <c:pt idx="1">
                    <c:v>1959.45833333333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S$26:$S$27</c:f>
              <c:numCache>
                <c:formatCode>General</c:formatCode>
                <c:ptCount val="2"/>
                <c:pt idx="0">
                  <c:v>181013.25</c:v>
                </c:pt>
                <c:pt idx="1">
                  <c:v>116487.208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18-4400-9E64-8F14E08E3D97}"/>
            </c:ext>
          </c:extLst>
        </c:ser>
        <c:ser>
          <c:idx val="1"/>
          <c:order val="1"/>
          <c:tx>
            <c:strRef>
              <c:f>'other cells'!$T$25</c:f>
              <c:strCache>
                <c:ptCount val="1"/>
                <c:pt idx="0">
                  <c:v>si-circNFATc3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T$28:$T$29</c:f>
                <c:numCache>
                  <c:formatCode>General</c:formatCode>
                  <c:ptCount val="2"/>
                  <c:pt idx="0">
                    <c:v>524.75</c:v>
                  </c:pt>
                  <c:pt idx="1">
                    <c:v>3670.90476190476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T$26:$T$27</c:f>
              <c:numCache>
                <c:formatCode>General</c:formatCode>
                <c:ptCount val="2"/>
                <c:pt idx="0">
                  <c:v>185888.5</c:v>
                </c:pt>
                <c:pt idx="1">
                  <c:v>122745.761904761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18-4400-9E64-8F14E08E3D97}"/>
            </c:ext>
          </c:extLst>
        </c:ser>
        <c:ser>
          <c:idx val="2"/>
          <c:order val="2"/>
          <c:tx>
            <c:strRef>
              <c:f>'other cells'!$U$25</c:f>
              <c:strCache>
                <c:ptCount val="1"/>
                <c:pt idx="0">
                  <c:v>si-circNFATC3-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U$28:$U$29</c:f>
                <c:numCache>
                  <c:formatCode>General</c:formatCode>
                  <c:ptCount val="2"/>
                  <c:pt idx="0">
                    <c:v>2890.3030303030391</c:v>
                  </c:pt>
                  <c:pt idx="1">
                    <c:v>990.71428571428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U$26:$U$27</c:f>
              <c:numCache>
                <c:formatCode>General</c:formatCode>
                <c:ptCount val="2"/>
                <c:pt idx="0">
                  <c:v>182344.9696969697</c:v>
                </c:pt>
                <c:pt idx="1">
                  <c:v>116765.285714285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18-4400-9E64-8F14E08E3D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8046720"/>
        <c:axId val="1539057616"/>
      </c:barChart>
      <c:catAx>
        <c:axId val="144804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9057616"/>
        <c:crosses val="autoZero"/>
        <c:auto val="1"/>
        <c:lblAlgn val="ctr"/>
        <c:lblOffset val="100"/>
        <c:noMultiLvlLbl val="0"/>
      </c:catAx>
      <c:valAx>
        <c:axId val="15390576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046720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2.xml.rels><?xml version="1.0" encoding="UTF-8" standalone="yes"?>
<Relationships xmlns="http://schemas.openxmlformats.org/package/2006/relationships"><Relationship Id="rId1" Type="http://schemas.openxmlformats.org/officeDocument/2006/relationships/image" Target="../media/image4.tiff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9786</cdr:x>
      <cdr:y>0.64025</cdr:y>
    </cdr:from>
    <cdr:to>
      <cdr:x>0.8256</cdr:x>
      <cdr:y>0.8126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995788" y="339558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Si-circNFATC3-1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9418</cdr:x>
      <cdr:y>0.69496</cdr:y>
    </cdr:from>
    <cdr:to>
      <cdr:x>0.8563</cdr:x>
      <cdr:y>0.8856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969411" y="3685735"/>
          <a:ext cx="1160585" cy="10111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Si-circNFACT3-2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6885</cdr:x>
      <cdr:y>0</cdr:y>
    </cdr:from>
    <cdr:to>
      <cdr:x>0.8747</cdr:x>
      <cdr:y>0.39619</cdr:y>
    </cdr:to>
    <cdr:pic>
      <cdr:nvPicPr>
        <cdr:cNvPr id="2" name="chart">
          <a:extLst xmlns:a="http://schemas.openxmlformats.org/drawingml/2006/main">
            <a:ext uri="{FF2B5EF4-FFF2-40B4-BE49-F238E27FC236}">
              <a16:creationId xmlns:a16="http://schemas.microsoft.com/office/drawing/2014/main" id="{DA9C2C86-F441-F443-8871-F246C63440A5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4243227" y="0"/>
          <a:ext cx="584200" cy="1309154"/>
        </a:xfrm>
        <a:prstGeom xmlns:a="http://schemas.openxmlformats.org/drawingml/2006/main" prst="rect">
          <a:avLst/>
        </a:prstGeom>
      </cdr:spPr>
    </cdr:pic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2437</cdr:x>
      <cdr:y>0.12818</cdr:y>
    </cdr:from>
    <cdr:to>
      <cdr:x>0.37901</cdr:x>
      <cdr:y>0.1755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11323" y="673016"/>
          <a:ext cx="765932" cy="2486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000" b="1"/>
            <a:t>Aerobic</a:t>
          </a:r>
        </a:p>
      </cdr:txBody>
    </cdr:sp>
  </cdr:relSizeAnchor>
  <cdr:relSizeAnchor xmlns:cdr="http://schemas.openxmlformats.org/drawingml/2006/chartDrawing">
    <cdr:from>
      <cdr:x>0.7577</cdr:x>
      <cdr:y>0.12713</cdr:y>
    </cdr:from>
    <cdr:to>
      <cdr:x>0.91749</cdr:x>
      <cdr:y>0.1732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3752911" y="667516"/>
          <a:ext cx="791440" cy="242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000" b="1" dirty="0"/>
            <a:t>Energetic</a:t>
          </a:r>
        </a:p>
      </cdr:txBody>
    </cdr:sp>
  </cdr:relSizeAnchor>
  <cdr:relSizeAnchor xmlns:cdr="http://schemas.openxmlformats.org/drawingml/2006/chartDrawing">
    <cdr:from>
      <cdr:x>0.74434</cdr:x>
      <cdr:y>0.57508</cdr:y>
    </cdr:from>
    <cdr:to>
      <cdr:x>0.90414</cdr:x>
      <cdr:y>0.62121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3686702" y="3019547"/>
          <a:ext cx="791489" cy="242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000" b="1"/>
            <a:t>Glycolytic</a:t>
          </a:r>
        </a:p>
      </cdr:txBody>
    </cdr:sp>
  </cdr:relSizeAnchor>
  <cdr:relSizeAnchor xmlns:cdr="http://schemas.openxmlformats.org/drawingml/2006/chartDrawing">
    <cdr:from>
      <cdr:x>0.21751</cdr:x>
      <cdr:y>0.57291</cdr:y>
    </cdr:from>
    <cdr:to>
      <cdr:x>0.3773</cdr:x>
      <cdr:y>0.61905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077327" y="3008166"/>
          <a:ext cx="791440" cy="2422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000" b="1"/>
            <a:t>Quiescent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.49296</cdr:y>
    </cdr:from>
    <cdr:to>
      <cdr:x>0.18097</cdr:x>
      <cdr:y>0.708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577E41C-996B-42BC-8EF6-74673523F571}"/>
            </a:ext>
          </a:extLst>
        </cdr:cNvPr>
        <cdr:cNvSpPr txBox="1"/>
      </cdr:nvSpPr>
      <cdr:spPr>
        <a:xfrm xmlns:a="http://schemas.openxmlformats.org/drawingml/2006/main" rot="16200000">
          <a:off x="0" y="209432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dirty="0"/>
            <a:t>Relative Luminescence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2A52B-DB35-4A2E-969A-51524580B7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E19EA3-746D-4CC7-BDD1-A79C5950C9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D114C9-336B-4D4E-A224-C6FB64CBF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3D7E4B-B40C-4E5C-88DE-A2D11FA51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DF27E9-932F-479B-B645-5D0BDF1EF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401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B534C1-7C0B-410D-B1BC-6ECF5B3CF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1BE327-B0A8-41E3-8A6E-AF56111CC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3F859E-B876-4B89-825F-1D343AD9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CEB182-5736-4803-9E0E-C1F155194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D1E5C-E5C4-4DC4-9038-F01F65743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66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8DF206-3A90-43CD-AF38-C448EF1DBD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36D928-F684-4EB6-92B5-5FC05F1AB4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C4B6AE-975A-4642-8435-3E49C42E4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8BDEF-6177-4593-BFC1-98290C9A9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21E9FE-8EB0-4393-9DC3-0CAEC236D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5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763565-8BE3-4B48-8C81-B8F7986B7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E431D6-047B-4649-9E1F-9DA64C793C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4457F-A232-4887-9161-62F93D337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11F4E-25F2-4666-9D99-040D44214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D455B-39C2-42FE-A6B9-92BE50CA9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857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C8F39-57D5-4AEE-958A-009391B21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87DA18-0C35-44AB-8B8F-95C887C243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27F65-E108-4679-A70E-9C0A0A1E3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7F83DE-DB83-4824-8BEA-97FA558EF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4B5D6-78B5-489E-9890-E49E62E7C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288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45C8C-E25D-4888-8FED-BE044499A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C979FA-7B8B-4BE7-9249-519FA6A52A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FF0BC9-7492-448E-BFAB-4FAE1E19D5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EB8E75-192F-497D-9DB7-6E121871B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A1D0EA-B18F-4675-BFA8-708755DD9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C74230-02A0-47C1-A1CF-32C23CD07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70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96483-B567-42FB-A735-645A71DAF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3E5691-FF55-49AB-BA71-B16E29EF47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D4CAFE-8A2C-41F5-94C3-BD656087C4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5C0350-97DC-428F-8A1F-6671CD0649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A322CA-0FAA-49A9-90BF-67BBBB44D0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3968FF-55A2-489B-A0A5-17A832C8E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C7BCCA-E572-40EB-9857-F530669AE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9381FA-95C0-453C-AF36-29001431A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5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9D0CE-31E7-4D52-83BF-0D4EE6EDF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B999B4-8FFB-49F2-8E7C-E0B4ACAAE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264BDB-7132-4BD0-B20D-3D61DD1FB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0F6AB5-453A-4487-A071-027175F9E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491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72571D-47F4-4231-9973-FF2BD2AD7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795D5E-2649-4DA3-9213-0393F24BB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21EF8E-F354-4A7E-A963-1CE9E5FBC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975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C7570-02D1-4CED-BBDE-4BF680641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87938-A0C1-4E42-B326-D3F1C847D9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2A49CD-7111-441F-80A2-FD1EDB416C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3BA18-E1E8-44C8-B4AB-2F09F2CBF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7A71CB-CFDA-4872-B063-B973513A8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5B1B5-F03D-4A55-965B-BDA9E9B24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036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4A0AF5-668B-4067-83CA-B826944D9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C25538-B18A-4F5A-B330-D53D234CE3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791103-01A1-4F48-8D0F-5B7BC09BA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E6342E-8893-4BD1-8E37-7EF8A4359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BDD343-FD65-4103-B6E7-63A4A867D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2FC842-6D57-4465-AB95-E9DEE8A24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56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E6D6C8-D4F1-4A9B-B4B2-D3863CDB9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6ABF26-A4C9-405C-91CD-B9EF15F9B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14B8B3-DB23-45ED-9C45-4AA04A40A2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C0C74-5219-4AD8-8F52-CA6760DD2491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10760-52F5-4E67-9AAA-2A21483C05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16D20-2C8B-4946-94C2-CB92C3CFD0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hyperlink" Target="http://syslab5.nchu.edu.tw/CircNet/" TargetMode="Externa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w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E4EDD4D-485A-9A45-BEB7-19936A13C6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305" y="718935"/>
            <a:ext cx="9523560" cy="26815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F34AFD-A4E4-824C-861B-15286446C5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1305" y="3400453"/>
            <a:ext cx="9523560" cy="26963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1855177" y="158262"/>
            <a:ext cx="2384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1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41305" y="644476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928161" y="6180998"/>
            <a:ext cx="8769753" cy="461665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1 : shows predicted activation or down regulation of function and genes involved  in siRNA mediated silencing od circNFATc3 cells compared to scrambled control. </a:t>
            </a:r>
          </a:p>
        </p:txBody>
      </p:sp>
    </p:spTree>
    <p:extLst>
      <p:ext uri="{BB962C8B-B14F-4D97-AF65-F5344CB8AC3E}">
        <p14:creationId xmlns:p14="http://schemas.microsoft.com/office/powerpoint/2010/main" val="40611712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873943C-20DC-454D-ADF4-4A32B98DD598}"/>
              </a:ext>
            </a:extLst>
          </p:cNvPr>
          <p:cNvSpPr/>
          <p:nvPr/>
        </p:nvSpPr>
        <p:spPr>
          <a:xfrm>
            <a:off x="442452" y="5860925"/>
            <a:ext cx="1562829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7:  Shows RNA binding proteins sites matching with circNFATC3  (https://circinteractome.nia.nih.gov)</a:t>
            </a:r>
          </a:p>
        </p:txBody>
      </p:sp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650DEC27-31A9-4C88-8409-6E5DCA79518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48" r="4212"/>
          <a:stretch/>
        </p:blipFill>
        <p:spPr>
          <a:xfrm>
            <a:off x="1899138" y="1195754"/>
            <a:ext cx="6523527" cy="407076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EF4C724-2EE1-4C3B-AD2A-774370AF7A95}"/>
              </a:ext>
            </a:extLst>
          </p:cNvPr>
          <p:cNvSpPr txBox="1"/>
          <p:nvPr/>
        </p:nvSpPr>
        <p:spPr>
          <a:xfrm>
            <a:off x="3207434" y="506437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7 </a:t>
            </a:r>
          </a:p>
        </p:txBody>
      </p:sp>
    </p:spTree>
    <p:extLst>
      <p:ext uri="{BB962C8B-B14F-4D97-AF65-F5344CB8AC3E}">
        <p14:creationId xmlns:p14="http://schemas.microsoft.com/office/powerpoint/2010/main" val="136921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143A770-3C33-4732-9E5B-3E4CCA4E9D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9686726"/>
              </p:ext>
            </p:extLst>
          </p:nvPr>
        </p:nvGraphicFramePr>
        <p:xfrm>
          <a:off x="2123758" y="1061232"/>
          <a:ext cx="7119937" cy="3998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Image" r:id="rId3" imgW="7120080" imgH="3998880" progId="Photoshop.Image.18">
                  <p:embed/>
                </p:oleObj>
              </mc:Choice>
              <mc:Fallback>
                <p:oleObj name="Image" r:id="rId3" imgW="7120080" imgH="399888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23758" y="1061232"/>
                        <a:ext cx="7119937" cy="399891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936631" y="43961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87062" y="5583115"/>
            <a:ext cx="7610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1: </a:t>
            </a:r>
            <a:r>
              <a:rPr lang="en-US" sz="1200" dirty="0" smtClean="0"/>
              <a:t>Real-time </a:t>
            </a:r>
            <a:r>
              <a:rPr lang="en-US" sz="1200" dirty="0"/>
              <a:t>validation of circNFATC3 silenced SKOV3 and MDA-MB231 cells  compared to control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1479537" y="3079513"/>
            <a:ext cx="1810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lative Expression (Log2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90665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BigChart">
            <a:extLst>
              <a:ext uri="{FF2B5EF4-FFF2-40B4-BE49-F238E27FC236}">
                <a16:creationId xmlns:a16="http://schemas.microsoft.com/office/drawing/2014/main" id="{88E3C7E5-2C05-45F3-902C-9422984608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5319137"/>
              </p:ext>
            </p:extLst>
          </p:nvPr>
        </p:nvGraphicFramePr>
        <p:xfrm>
          <a:off x="1378635" y="815927"/>
          <a:ext cx="7158696" cy="53035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261946" y="1855177"/>
            <a:ext cx="850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52092" y="325315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6716" y="5873262"/>
            <a:ext cx="12567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2: Mitochondrial respiration measured in </a:t>
            </a:r>
            <a:r>
              <a:rPr lang="en-US" sz="1200" dirty="0" err="1"/>
              <a:t>ocr</a:t>
            </a:r>
            <a:r>
              <a:rPr lang="en-US" sz="1200" dirty="0"/>
              <a:t>(</a:t>
            </a:r>
            <a:r>
              <a:rPr lang="en-US" sz="1200" dirty="0" err="1"/>
              <a:t>pmol</a:t>
            </a:r>
            <a:r>
              <a:rPr lang="en-US" sz="1200" dirty="0"/>
              <a:t>/min) in SKOV3 cell line (si-circNFATC3 </a:t>
            </a:r>
            <a:r>
              <a:rPr lang="en-US" sz="1200" dirty="0" err="1"/>
              <a:t>vs.Control</a:t>
            </a:r>
            <a:r>
              <a:rPr lang="en-US" sz="1200" dirty="0"/>
              <a:t>) using Seahorse XF96  analyzer </a:t>
            </a:r>
          </a:p>
        </p:txBody>
      </p:sp>
    </p:spTree>
    <p:extLst>
      <p:ext uri="{BB962C8B-B14F-4D97-AF65-F5344CB8AC3E}">
        <p14:creationId xmlns:p14="http://schemas.microsoft.com/office/powerpoint/2010/main" val="6290447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BigChart">
            <a:extLst>
              <a:ext uri="{FF2B5EF4-FFF2-40B4-BE49-F238E27FC236}">
                <a16:creationId xmlns:a16="http://schemas.microsoft.com/office/drawing/2014/main" id="{00000000-0008-0000-04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8617896"/>
              </p:ext>
            </p:extLst>
          </p:nvPr>
        </p:nvGraphicFramePr>
        <p:xfrm>
          <a:off x="622511" y="745677"/>
          <a:ext cx="5518944" cy="33043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SubChart2">
            <a:extLst>
              <a:ext uri="{FF2B5EF4-FFF2-40B4-BE49-F238E27FC236}">
                <a16:creationId xmlns:a16="http://schemas.microsoft.com/office/drawing/2014/main" id="{00000000-0008-0000-0400-00001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5514128"/>
              </p:ext>
            </p:extLst>
          </p:nvPr>
        </p:nvGraphicFramePr>
        <p:xfrm>
          <a:off x="7017729" y="572099"/>
          <a:ext cx="4709343" cy="3396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AA8F9EA-A322-534F-9889-0D642C6B5E35}"/>
              </a:ext>
            </a:extLst>
          </p:cNvPr>
          <p:cNvSpPr txBox="1"/>
          <p:nvPr/>
        </p:nvSpPr>
        <p:spPr>
          <a:xfrm>
            <a:off x="5352836" y="842483"/>
            <a:ext cx="16546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ircular mini vector+alu+nfatc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D85F56-E065-9949-A04D-B4C0FFADD1FC}"/>
              </a:ext>
            </a:extLst>
          </p:cNvPr>
          <p:cNvSpPr txBox="1"/>
          <p:nvPr/>
        </p:nvSpPr>
        <p:spPr>
          <a:xfrm>
            <a:off x="5496674" y="1171255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Empty vector+ </a:t>
            </a:r>
            <a:r>
              <a:rPr lang="en-US" sz="1000" dirty="0" err="1"/>
              <a:t>alu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A4B7E5-11F9-9B46-84B1-6A08C8D38B93}"/>
              </a:ext>
            </a:extLst>
          </p:cNvPr>
          <p:cNvSpPr txBox="1"/>
          <p:nvPr/>
        </p:nvSpPr>
        <p:spPr>
          <a:xfrm>
            <a:off x="5486400" y="1376380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Empty PCDNA3.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D07668-7461-0749-BA61-8268103CB989}"/>
              </a:ext>
            </a:extLst>
          </p:cNvPr>
          <p:cNvSpPr txBox="1"/>
          <p:nvPr/>
        </p:nvSpPr>
        <p:spPr>
          <a:xfrm>
            <a:off x="5435032" y="1715785"/>
            <a:ext cx="11961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CDNA3.1+NFATC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0" y="4955586"/>
            <a:ext cx="1172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 Figure 3 : Mitochondrial respiration analyzed in SKOV3 cells over expressed with circNFATC3 and its control conditions( Empty </a:t>
            </a:r>
            <a:r>
              <a:rPr lang="en-US" sz="1200" dirty="0" err="1"/>
              <a:t>vector+alu</a:t>
            </a:r>
            <a:r>
              <a:rPr lang="en-US" sz="1200" dirty="0"/>
              <a:t>, NFATc3 +PCDNA3.1, PCDN3.1).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387361" y="404446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 Figure 3</a:t>
            </a:r>
          </a:p>
        </p:txBody>
      </p:sp>
    </p:spTree>
    <p:extLst>
      <p:ext uri="{BB962C8B-B14F-4D97-AF65-F5344CB8AC3E}">
        <p14:creationId xmlns:p14="http://schemas.microsoft.com/office/powerpoint/2010/main" val="3085257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DBAD09-D433-3F46-BF1E-7606F5DE229E}"/>
              </a:ext>
            </a:extLst>
          </p:cNvPr>
          <p:cNvSpPr txBox="1"/>
          <p:nvPr/>
        </p:nvSpPr>
        <p:spPr>
          <a:xfrm>
            <a:off x="5116530" y="-4603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 Figure 4</a:t>
            </a:r>
          </a:p>
        </p:txBody>
      </p:sp>
      <p:graphicFrame>
        <p:nvGraphicFramePr>
          <p:cNvPr id="5" name="OCR Chart">
            <a:extLst>
              <a:ext uri="{FF2B5EF4-FFF2-40B4-BE49-F238E27FC236}">
                <a16:creationId xmlns:a16="http://schemas.microsoft.com/office/drawing/2014/main" id="{00000000-0008-0000-0B00-00000E000000}"/>
              </a:ext>
            </a:extLst>
          </p:cNvPr>
          <p:cNvGraphicFramePr>
            <a:graphicFrameLocks/>
          </p:cNvGraphicFramePr>
          <p:nvPr/>
        </p:nvGraphicFramePr>
        <p:xfrm>
          <a:off x="6467597" y="1038259"/>
          <a:ext cx="5113073" cy="5192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ScatterChart">
            <a:extLst>
              <a:ext uri="{FF2B5EF4-FFF2-40B4-BE49-F238E27FC236}">
                <a16:creationId xmlns:a16="http://schemas.microsoft.com/office/drawing/2014/main" id="{00000000-0008-0000-0B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8791044"/>
              </p:ext>
            </p:extLst>
          </p:nvPr>
        </p:nvGraphicFramePr>
        <p:xfrm>
          <a:off x="249001" y="1294365"/>
          <a:ext cx="5675313" cy="5206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91308" y="5345723"/>
            <a:ext cx="9766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 Figure 4 : energy phenotype measured by seahorse Flux analyzer in SKOV3 cells over expressed with circNFATC3 construct and its controls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A8F9EA-A322-534F-9889-0D642C6B5E35}"/>
              </a:ext>
            </a:extLst>
          </p:cNvPr>
          <p:cNvSpPr txBox="1"/>
          <p:nvPr/>
        </p:nvSpPr>
        <p:spPr>
          <a:xfrm>
            <a:off x="5344044" y="886443"/>
            <a:ext cx="2131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ircular mini vector+alu+nfatc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D85F56-E065-9949-A04D-B4C0FFADD1FC}"/>
              </a:ext>
            </a:extLst>
          </p:cNvPr>
          <p:cNvSpPr txBox="1"/>
          <p:nvPr/>
        </p:nvSpPr>
        <p:spPr>
          <a:xfrm>
            <a:off x="5329620" y="1171255"/>
            <a:ext cx="1314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mpty vector+ </a:t>
            </a:r>
            <a:r>
              <a:rPr lang="en-US" sz="1200" dirty="0" err="1"/>
              <a:t>alu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A4B7E5-11F9-9B46-84B1-6A08C8D38B93}"/>
              </a:ext>
            </a:extLst>
          </p:cNvPr>
          <p:cNvSpPr txBox="1"/>
          <p:nvPr/>
        </p:nvSpPr>
        <p:spPr>
          <a:xfrm>
            <a:off x="5380894" y="1376380"/>
            <a:ext cx="12595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mpty PCDNA3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D07668-7461-0749-BA61-8268103CB989}"/>
              </a:ext>
            </a:extLst>
          </p:cNvPr>
          <p:cNvSpPr txBox="1"/>
          <p:nvPr/>
        </p:nvSpPr>
        <p:spPr>
          <a:xfrm>
            <a:off x="5320732" y="1680617"/>
            <a:ext cx="13742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CDNA3.1+NFATC3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116530" y="957899"/>
            <a:ext cx="177942" cy="115416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5125788" y="1260513"/>
            <a:ext cx="177942" cy="11541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5125788" y="1441331"/>
            <a:ext cx="177942" cy="115416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5116530" y="1723479"/>
            <a:ext cx="177942" cy="115416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351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1A2C765-60D0-4F3B-9651-4972F90403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1965073"/>
              </p:ext>
            </p:extLst>
          </p:nvPr>
        </p:nvGraphicFramePr>
        <p:xfrm>
          <a:off x="5560313" y="744690"/>
          <a:ext cx="6194707" cy="52244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Image" r:id="rId3" imgW="3047760" imgH="2072520" progId="Photoshop.Image.18">
                  <p:embed/>
                </p:oleObj>
              </mc:Choice>
              <mc:Fallback>
                <p:oleObj name="Image" r:id="rId3" imgW="3047760" imgH="207252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60313" y="744690"/>
                        <a:ext cx="6194707" cy="522446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4260C7D-AE16-4768-BF14-F8673FE869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4986311"/>
              </p:ext>
            </p:extLst>
          </p:nvPr>
        </p:nvGraphicFramePr>
        <p:xfrm>
          <a:off x="436980" y="789477"/>
          <a:ext cx="5021285" cy="51348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Image" r:id="rId5" imgW="3508200" imgH="3587400" progId="Photoshop.Image.18">
                  <p:embed/>
                </p:oleObj>
              </mc:Choice>
              <mc:Fallback>
                <p:oleObj name="Image" r:id="rId5" imgW="3508200" imgH="358740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6980" y="789477"/>
                        <a:ext cx="5021285" cy="513488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55277" y="316523"/>
            <a:ext cx="2484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36980" y="31657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794131" y="43778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1354" y="6339254"/>
            <a:ext cx="1164248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5: A. Expression of circNFATC3 across the tissue types (</a:t>
            </a:r>
            <a:r>
              <a:rPr lang="en-US" sz="1200" dirty="0" err="1"/>
              <a:t>cirNet</a:t>
            </a:r>
            <a:r>
              <a:rPr lang="en-US" sz="1200" dirty="0"/>
              <a:t> analysis </a:t>
            </a:r>
            <a:r>
              <a:rPr lang="en-US" sz="1200" dirty="0">
                <a:hlinkClick r:id="rId7"/>
              </a:rPr>
              <a:t>http://syslab5.nchu.edu.tw/CircNet/</a:t>
            </a:r>
            <a:r>
              <a:rPr lang="en-US" sz="1200" dirty="0"/>
              <a:t>). B . Expression of circNFATc3 in cancer and normal cells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09024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531C58F-35D3-45A1-B4B0-C0564346AA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9513608"/>
              </p:ext>
            </p:extLst>
          </p:nvPr>
        </p:nvGraphicFramePr>
        <p:xfrm>
          <a:off x="1392347" y="949624"/>
          <a:ext cx="4900078" cy="42835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9464F2C-DDF1-40D8-9B2F-6794B5A740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1335755"/>
              </p:ext>
            </p:extLst>
          </p:nvPr>
        </p:nvGraphicFramePr>
        <p:xfrm>
          <a:off x="6602125" y="996735"/>
          <a:ext cx="5170290" cy="42364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1B7B87A-8C10-4ABE-839F-17211CB8A21D}"/>
              </a:ext>
            </a:extLst>
          </p:cNvPr>
          <p:cNvSpPr txBox="1"/>
          <p:nvPr/>
        </p:nvSpPr>
        <p:spPr>
          <a:xfrm rot="16200000">
            <a:off x="380622" y="2527158"/>
            <a:ext cx="1658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D at 49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08131" y="290146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4931" y="5802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292425" y="94962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25189" y="5609492"/>
            <a:ext cx="106468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6:A. Shows proliferation of LCL cells both healthy and TNBC cells silenced with</a:t>
            </a:r>
          </a:p>
          <a:p>
            <a:r>
              <a:rPr lang="en-US" sz="1200" dirty="0"/>
              <a:t> circNFATC3 constructs and scrambled control. B. Shows ATP production in similar conditions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39716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EBCC8-EBD6-442B-9CD6-C2D5E5E0D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1885" y="778364"/>
            <a:ext cx="11221915" cy="1325563"/>
          </a:xfrm>
        </p:spPr>
        <p:txBody>
          <a:bodyPr>
            <a:normAutofit/>
          </a:bodyPr>
          <a:lstStyle/>
          <a:p>
            <a:pPr algn="ctr"/>
            <a:r>
              <a:rPr lang="en-US" sz="1800" dirty="0" err="1"/>
              <a:t>starBase</a:t>
            </a:r>
            <a:r>
              <a:rPr lang="en-US" sz="1800" dirty="0"/>
              <a:t> cirNFATC3-miRNA interactome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D146DDC-DC84-4129-908D-60166A3425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6687442"/>
              </p:ext>
            </p:extLst>
          </p:nvPr>
        </p:nvGraphicFramePr>
        <p:xfrm>
          <a:off x="1065628" y="1874227"/>
          <a:ext cx="8675273" cy="35910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4730">
                  <a:extLst>
                    <a:ext uri="{9D8B030D-6E8A-4147-A177-3AD203B41FA5}">
                      <a16:colId xmlns:a16="http://schemas.microsoft.com/office/drawing/2014/main" val="2926933142"/>
                    </a:ext>
                  </a:extLst>
                </a:gridCol>
                <a:gridCol w="1396715">
                  <a:extLst>
                    <a:ext uri="{9D8B030D-6E8A-4147-A177-3AD203B41FA5}">
                      <a16:colId xmlns:a16="http://schemas.microsoft.com/office/drawing/2014/main" val="504360098"/>
                    </a:ext>
                  </a:extLst>
                </a:gridCol>
                <a:gridCol w="2274549">
                  <a:extLst>
                    <a:ext uri="{9D8B030D-6E8A-4147-A177-3AD203B41FA5}">
                      <a16:colId xmlns:a16="http://schemas.microsoft.com/office/drawing/2014/main" val="3230872322"/>
                    </a:ext>
                  </a:extLst>
                </a:gridCol>
                <a:gridCol w="1037763">
                  <a:extLst>
                    <a:ext uri="{9D8B030D-6E8A-4147-A177-3AD203B41FA5}">
                      <a16:colId xmlns:a16="http://schemas.microsoft.com/office/drawing/2014/main" val="3865038912"/>
                    </a:ext>
                  </a:extLst>
                </a:gridCol>
                <a:gridCol w="1563753">
                  <a:extLst>
                    <a:ext uri="{9D8B030D-6E8A-4147-A177-3AD203B41FA5}">
                      <a16:colId xmlns:a16="http://schemas.microsoft.com/office/drawing/2014/main" val="2168053501"/>
                    </a:ext>
                  </a:extLst>
                </a:gridCol>
                <a:gridCol w="1037763">
                  <a:extLst>
                    <a:ext uri="{9D8B030D-6E8A-4147-A177-3AD203B41FA5}">
                      <a16:colId xmlns:a16="http://schemas.microsoft.com/office/drawing/2014/main" val="763701863"/>
                    </a:ext>
                  </a:extLst>
                </a:gridCol>
              </a:tblGrid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Nam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rAccessio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eneNam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</a:rPr>
                        <a:t>targetSit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ioComplex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lipReadNum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17218395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sa-let-7a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0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NFATC3_hsa-circRNA306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83584654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let-7b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0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0079041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sa-let-7e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0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9327301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let-7g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4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41267258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let-7i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4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52775528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sa-miR-143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4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76024365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miR-185-5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04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75994736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sa-miR-18b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14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2652469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miR-202-3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028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39752333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miR-43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168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87211461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miR-46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197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67537206"/>
                  </a:ext>
                </a:extLst>
              </a:tr>
              <a:tr h="27623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sa-miR-477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IMAT00199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FATC3_hsa-circRNA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8833674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065628" y="1874227"/>
            <a:ext cx="8675273" cy="3591068"/>
          </a:xfrm>
          <a:prstGeom prst="rect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508131" y="290146"/>
            <a:ext cx="2760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 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86962" y="5846885"/>
            <a:ext cx="436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7: </a:t>
            </a:r>
            <a:r>
              <a:rPr lang="en-US" sz="1200" dirty="0" err="1"/>
              <a:t>circRNA</a:t>
            </a:r>
            <a:r>
              <a:rPr lang="en-US" sz="1200" dirty="0"/>
              <a:t> </a:t>
            </a:r>
            <a:r>
              <a:rPr lang="en-US" sz="1200" dirty="0" err="1"/>
              <a:t>interactome</a:t>
            </a:r>
            <a:r>
              <a:rPr lang="en-US" sz="1200" dirty="0"/>
              <a:t> study using </a:t>
            </a:r>
            <a:r>
              <a:rPr lang="en-US" sz="1200" dirty="0" err="1"/>
              <a:t>starBase</a:t>
            </a:r>
            <a:r>
              <a:rPr lang="en-US" sz="1200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6692983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91FAB86-1DC0-4369-8611-9DCB5A492A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7889883"/>
              </p:ext>
            </p:extLst>
          </p:nvPr>
        </p:nvGraphicFramePr>
        <p:xfrm>
          <a:off x="1491175" y="1026942"/>
          <a:ext cx="8187397" cy="4783022"/>
        </p:xfrm>
        <a:graphic>
          <a:graphicData uri="http://schemas.openxmlformats.org/drawingml/2006/table">
            <a:tbl>
              <a:tblPr/>
              <a:tblGrid>
                <a:gridCol w="1181487">
                  <a:extLst>
                    <a:ext uri="{9D8B030D-6E8A-4147-A177-3AD203B41FA5}">
                      <a16:colId xmlns:a16="http://schemas.microsoft.com/office/drawing/2014/main" val="3049785787"/>
                    </a:ext>
                  </a:extLst>
                </a:gridCol>
                <a:gridCol w="1451839">
                  <a:extLst>
                    <a:ext uri="{9D8B030D-6E8A-4147-A177-3AD203B41FA5}">
                      <a16:colId xmlns:a16="http://schemas.microsoft.com/office/drawing/2014/main" val="3153694427"/>
                    </a:ext>
                  </a:extLst>
                </a:gridCol>
                <a:gridCol w="1302584">
                  <a:extLst>
                    <a:ext uri="{9D8B030D-6E8A-4147-A177-3AD203B41FA5}">
                      <a16:colId xmlns:a16="http://schemas.microsoft.com/office/drawing/2014/main" val="3325892525"/>
                    </a:ext>
                  </a:extLst>
                </a:gridCol>
                <a:gridCol w="868388">
                  <a:extLst>
                    <a:ext uri="{9D8B030D-6E8A-4147-A177-3AD203B41FA5}">
                      <a16:colId xmlns:a16="http://schemas.microsoft.com/office/drawing/2014/main" val="1862768427"/>
                    </a:ext>
                  </a:extLst>
                </a:gridCol>
                <a:gridCol w="1103578">
                  <a:extLst>
                    <a:ext uri="{9D8B030D-6E8A-4147-A177-3AD203B41FA5}">
                      <a16:colId xmlns:a16="http://schemas.microsoft.com/office/drawing/2014/main" val="3961053485"/>
                    </a:ext>
                  </a:extLst>
                </a:gridCol>
                <a:gridCol w="1194035">
                  <a:extLst>
                    <a:ext uri="{9D8B030D-6E8A-4147-A177-3AD203B41FA5}">
                      <a16:colId xmlns:a16="http://schemas.microsoft.com/office/drawing/2014/main" val="2771757690"/>
                    </a:ext>
                  </a:extLst>
                </a:gridCol>
                <a:gridCol w="1085486">
                  <a:extLst>
                    <a:ext uri="{9D8B030D-6E8A-4147-A177-3AD203B41FA5}">
                      <a16:colId xmlns:a16="http://schemas.microsoft.com/office/drawing/2014/main" val="1018814241"/>
                    </a:ext>
                  </a:extLst>
                </a:gridCol>
              </a:tblGrid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I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Nam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Typ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usterN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pExpN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ipIDnu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1610265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DX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1647816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GCR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0859529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AVL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3006990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MR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8943054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A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0877397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3060289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7099853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3573193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BP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9522280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BP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2041675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2BP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1433148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N28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1034675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V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4730980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FOX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3434461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RSF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128940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F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0973807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DB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977476"/>
                  </a:ext>
                </a:extLst>
              </a:tr>
              <a:tr h="25173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2AF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M_0045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FATC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RN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6707598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7E02350-CA68-4755-85CD-5DE9F9865EC0}"/>
              </a:ext>
            </a:extLst>
          </p:cNvPr>
          <p:cNvSpPr txBox="1"/>
          <p:nvPr/>
        </p:nvSpPr>
        <p:spPr>
          <a:xfrm>
            <a:off x="3235569" y="422031"/>
            <a:ext cx="2331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35A9F9-363A-4E3F-9147-6C57A734AE76}"/>
              </a:ext>
            </a:extLst>
          </p:cNvPr>
          <p:cNvSpPr txBox="1"/>
          <p:nvPr/>
        </p:nvSpPr>
        <p:spPr>
          <a:xfrm>
            <a:off x="647114" y="6077242"/>
            <a:ext cx="109058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3: RBP-RNA interactions supported by the binding sites of RBPs derived from CLIP-seq data (</a:t>
            </a:r>
            <a:r>
              <a:rPr lang="en-US" dirty="0" err="1"/>
              <a:t>starBase</a:t>
            </a:r>
            <a:r>
              <a:rPr lang="en-U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19391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6</TotalTime>
  <Words>551</Words>
  <Application>Microsoft Office PowerPoint</Application>
  <PresentationFormat>Widescreen</PresentationFormat>
  <Paragraphs>267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tarBase cirNFATC3-miRNA interactome.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sni aziz</dc:creator>
  <cp:lastModifiedBy>Thasni Karedath Abdul Azis</cp:lastModifiedBy>
  <cp:revision>27</cp:revision>
  <dcterms:created xsi:type="dcterms:W3CDTF">2019-07-03T17:24:30Z</dcterms:created>
  <dcterms:modified xsi:type="dcterms:W3CDTF">2019-08-01T05:32:27Z</dcterms:modified>
</cp:coreProperties>
</file>